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0698163" cy="7562850"/>
  <p:notesSz cx="6858000" cy="9144000"/>
  <p:defaultTextStyle>
    <a:defPPr>
      <a:defRPr lang="en-US"/>
    </a:defPPr>
    <a:lvl1pPr marL="0" algn="l" defTabSz="99596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1pPr>
    <a:lvl2pPr marL="497982" algn="l" defTabSz="99596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2pPr>
    <a:lvl3pPr marL="995964" algn="l" defTabSz="99596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3pPr>
    <a:lvl4pPr marL="1493947" algn="l" defTabSz="99596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4pPr>
    <a:lvl5pPr marL="1991929" algn="l" defTabSz="99596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5pPr>
    <a:lvl6pPr marL="2489911" algn="l" defTabSz="99596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6pPr>
    <a:lvl7pPr marL="2987893" algn="l" defTabSz="99596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7pPr>
    <a:lvl8pPr marL="3485876" algn="l" defTabSz="99596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8pPr>
    <a:lvl9pPr marL="3983858" algn="l" defTabSz="99596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82">
          <p15:clr>
            <a:srgbClr val="A4A3A4"/>
          </p15:clr>
        </p15:guide>
        <p15:guide id="2" pos="337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59" d="100"/>
          <a:sy n="59" d="100"/>
        </p:scale>
        <p:origin x="1350" y="78"/>
      </p:cViewPr>
      <p:guideLst>
        <p:guide orient="horz" pos="2382"/>
        <p:guide pos="33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2362" y="2349388"/>
            <a:ext cx="9093439" cy="162111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04725" y="4285615"/>
            <a:ext cx="7488714" cy="193272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979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959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9394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9192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899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9878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4858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9838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5D40C-A8DC-479A-A5D3-E7B4936A184B}" type="datetimeFigureOut">
              <a:rPr lang="en-GB" smtClean="0"/>
              <a:t>15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35FAC-C7EA-4164-B888-497B3F49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6263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5D40C-A8DC-479A-A5D3-E7B4936A184B}" type="datetimeFigureOut">
              <a:rPr lang="en-GB" smtClean="0"/>
              <a:t>15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35FAC-C7EA-4164-B888-497B3F49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46033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402515" y="302867"/>
            <a:ext cx="2607678" cy="645293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79485" y="302867"/>
            <a:ext cx="7644730" cy="645293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5D40C-A8DC-479A-A5D3-E7B4936A184B}" type="datetimeFigureOut">
              <a:rPr lang="en-GB" smtClean="0"/>
              <a:t>15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35FAC-C7EA-4164-B888-497B3F49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57309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5D40C-A8DC-479A-A5D3-E7B4936A184B}" type="datetimeFigureOut">
              <a:rPr lang="en-GB" smtClean="0"/>
              <a:t>15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35FAC-C7EA-4164-B888-497B3F49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24996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5081" y="4859833"/>
            <a:ext cx="9093439" cy="1502066"/>
          </a:xfrm>
        </p:spPr>
        <p:txBody>
          <a:bodyPr anchor="t"/>
          <a:lstStyle>
            <a:lvl1pPr algn="l">
              <a:defRPr sz="44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5081" y="3205460"/>
            <a:ext cx="9093439" cy="1654373"/>
          </a:xfrm>
        </p:spPr>
        <p:txBody>
          <a:bodyPr anchor="b"/>
          <a:lstStyle>
            <a:lvl1pPr marL="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1pPr>
            <a:lvl2pPr marL="49798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95964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3pPr>
            <a:lvl4pPr marL="1493947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4pPr>
            <a:lvl5pPr marL="1991929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5pPr>
            <a:lvl6pPr marL="248991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6pPr>
            <a:lvl7pPr marL="2987893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7pPr>
            <a:lvl8pPr marL="348587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8pPr>
            <a:lvl9pPr marL="3983858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5D40C-A8DC-479A-A5D3-E7B4936A184B}" type="datetimeFigureOut">
              <a:rPr lang="en-GB" smtClean="0"/>
              <a:t>15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35FAC-C7EA-4164-B888-497B3F49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13276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79486" y="1764667"/>
            <a:ext cx="5126203" cy="4991131"/>
          </a:xfrm>
        </p:spPr>
        <p:txBody>
          <a:bodyPr/>
          <a:lstStyle>
            <a:lvl1pPr>
              <a:defRPr sz="3000"/>
            </a:lvl1pPr>
            <a:lvl2pPr>
              <a:defRPr sz="26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883991" y="1764667"/>
            <a:ext cx="5126203" cy="4991131"/>
          </a:xfrm>
        </p:spPr>
        <p:txBody>
          <a:bodyPr/>
          <a:lstStyle>
            <a:lvl1pPr>
              <a:defRPr sz="3000"/>
            </a:lvl1pPr>
            <a:lvl2pPr>
              <a:defRPr sz="26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5D40C-A8DC-479A-A5D3-E7B4936A184B}" type="datetimeFigureOut">
              <a:rPr lang="en-GB" smtClean="0"/>
              <a:t>15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35FAC-C7EA-4164-B888-497B3F49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31403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4908" y="302865"/>
            <a:ext cx="9628347" cy="1260475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909" y="1692889"/>
            <a:ext cx="4726880" cy="705515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7982" indent="0">
              <a:buNone/>
              <a:defRPr sz="2200" b="1"/>
            </a:lvl2pPr>
            <a:lvl3pPr marL="995964" indent="0">
              <a:buNone/>
              <a:defRPr sz="2000" b="1"/>
            </a:lvl3pPr>
            <a:lvl4pPr marL="1493947" indent="0">
              <a:buNone/>
              <a:defRPr sz="1700" b="1"/>
            </a:lvl4pPr>
            <a:lvl5pPr marL="1991929" indent="0">
              <a:buNone/>
              <a:defRPr sz="1700" b="1"/>
            </a:lvl5pPr>
            <a:lvl6pPr marL="2489911" indent="0">
              <a:buNone/>
              <a:defRPr sz="1700" b="1"/>
            </a:lvl6pPr>
            <a:lvl7pPr marL="2987893" indent="0">
              <a:buNone/>
              <a:defRPr sz="1700" b="1"/>
            </a:lvl7pPr>
            <a:lvl8pPr marL="3485876" indent="0">
              <a:buNone/>
              <a:defRPr sz="1700" b="1"/>
            </a:lvl8pPr>
            <a:lvl9pPr marL="3983858" indent="0">
              <a:buNone/>
              <a:defRPr sz="17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4909" y="2398404"/>
            <a:ext cx="4726880" cy="4357393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20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34519" y="1692889"/>
            <a:ext cx="4728738" cy="705515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7982" indent="0">
              <a:buNone/>
              <a:defRPr sz="2200" b="1"/>
            </a:lvl2pPr>
            <a:lvl3pPr marL="995964" indent="0">
              <a:buNone/>
              <a:defRPr sz="2000" b="1"/>
            </a:lvl3pPr>
            <a:lvl4pPr marL="1493947" indent="0">
              <a:buNone/>
              <a:defRPr sz="1700" b="1"/>
            </a:lvl4pPr>
            <a:lvl5pPr marL="1991929" indent="0">
              <a:buNone/>
              <a:defRPr sz="1700" b="1"/>
            </a:lvl5pPr>
            <a:lvl6pPr marL="2489911" indent="0">
              <a:buNone/>
              <a:defRPr sz="1700" b="1"/>
            </a:lvl6pPr>
            <a:lvl7pPr marL="2987893" indent="0">
              <a:buNone/>
              <a:defRPr sz="1700" b="1"/>
            </a:lvl7pPr>
            <a:lvl8pPr marL="3485876" indent="0">
              <a:buNone/>
              <a:defRPr sz="1700" b="1"/>
            </a:lvl8pPr>
            <a:lvl9pPr marL="3983858" indent="0">
              <a:buNone/>
              <a:defRPr sz="17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34519" y="2398404"/>
            <a:ext cx="4728738" cy="4357393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20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5D40C-A8DC-479A-A5D3-E7B4936A184B}" type="datetimeFigureOut">
              <a:rPr lang="en-GB" smtClean="0"/>
              <a:t>15/09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35FAC-C7EA-4164-B888-497B3F49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0559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5D40C-A8DC-479A-A5D3-E7B4936A184B}" type="datetimeFigureOut">
              <a:rPr lang="en-GB" smtClean="0"/>
              <a:t>15/09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35FAC-C7EA-4164-B888-497B3F49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15641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5D40C-A8DC-479A-A5D3-E7B4936A184B}" type="datetimeFigureOut">
              <a:rPr lang="en-GB" smtClean="0"/>
              <a:t>15/09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35FAC-C7EA-4164-B888-497B3F49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18188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4909" y="301113"/>
            <a:ext cx="3519622" cy="1281483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182686" y="301116"/>
            <a:ext cx="5980569" cy="6454683"/>
          </a:xfrm>
        </p:spPr>
        <p:txBody>
          <a:bodyPr/>
          <a:lstStyle>
            <a:lvl1pPr>
              <a:defRPr sz="3500"/>
            </a:lvl1pPr>
            <a:lvl2pPr>
              <a:defRPr sz="3000"/>
            </a:lvl2pPr>
            <a:lvl3pPr>
              <a:defRPr sz="26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4909" y="1582598"/>
            <a:ext cx="3519622" cy="5173200"/>
          </a:xfrm>
        </p:spPr>
        <p:txBody>
          <a:bodyPr/>
          <a:lstStyle>
            <a:lvl1pPr marL="0" indent="0">
              <a:buNone/>
              <a:defRPr sz="1500"/>
            </a:lvl1pPr>
            <a:lvl2pPr marL="497982" indent="0">
              <a:buNone/>
              <a:defRPr sz="1300"/>
            </a:lvl2pPr>
            <a:lvl3pPr marL="995964" indent="0">
              <a:buNone/>
              <a:defRPr sz="1100"/>
            </a:lvl3pPr>
            <a:lvl4pPr marL="1493947" indent="0">
              <a:buNone/>
              <a:defRPr sz="1000"/>
            </a:lvl4pPr>
            <a:lvl5pPr marL="1991929" indent="0">
              <a:buNone/>
              <a:defRPr sz="1000"/>
            </a:lvl5pPr>
            <a:lvl6pPr marL="2489911" indent="0">
              <a:buNone/>
              <a:defRPr sz="1000"/>
            </a:lvl6pPr>
            <a:lvl7pPr marL="2987893" indent="0">
              <a:buNone/>
              <a:defRPr sz="1000"/>
            </a:lvl7pPr>
            <a:lvl8pPr marL="3485876" indent="0">
              <a:buNone/>
              <a:defRPr sz="1000"/>
            </a:lvl8pPr>
            <a:lvl9pPr marL="3983858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5D40C-A8DC-479A-A5D3-E7B4936A184B}" type="datetimeFigureOut">
              <a:rPr lang="en-GB" smtClean="0"/>
              <a:t>15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35FAC-C7EA-4164-B888-497B3F49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08045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96914" y="5293995"/>
            <a:ext cx="6418898" cy="624986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096914" y="675755"/>
            <a:ext cx="6418898" cy="4537710"/>
          </a:xfrm>
        </p:spPr>
        <p:txBody>
          <a:bodyPr/>
          <a:lstStyle>
            <a:lvl1pPr marL="0" indent="0">
              <a:buNone/>
              <a:defRPr sz="3500"/>
            </a:lvl1pPr>
            <a:lvl2pPr marL="497982" indent="0">
              <a:buNone/>
              <a:defRPr sz="3000"/>
            </a:lvl2pPr>
            <a:lvl3pPr marL="995964" indent="0">
              <a:buNone/>
              <a:defRPr sz="2600"/>
            </a:lvl3pPr>
            <a:lvl4pPr marL="1493947" indent="0">
              <a:buNone/>
              <a:defRPr sz="2200"/>
            </a:lvl4pPr>
            <a:lvl5pPr marL="1991929" indent="0">
              <a:buNone/>
              <a:defRPr sz="2200"/>
            </a:lvl5pPr>
            <a:lvl6pPr marL="2489911" indent="0">
              <a:buNone/>
              <a:defRPr sz="2200"/>
            </a:lvl6pPr>
            <a:lvl7pPr marL="2987893" indent="0">
              <a:buNone/>
              <a:defRPr sz="2200"/>
            </a:lvl7pPr>
            <a:lvl8pPr marL="3485876" indent="0">
              <a:buNone/>
              <a:defRPr sz="2200"/>
            </a:lvl8pPr>
            <a:lvl9pPr marL="3983858" indent="0">
              <a:buNone/>
              <a:defRPr sz="22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96914" y="5918981"/>
            <a:ext cx="6418898" cy="887584"/>
          </a:xfrm>
        </p:spPr>
        <p:txBody>
          <a:bodyPr/>
          <a:lstStyle>
            <a:lvl1pPr marL="0" indent="0">
              <a:buNone/>
              <a:defRPr sz="1500"/>
            </a:lvl1pPr>
            <a:lvl2pPr marL="497982" indent="0">
              <a:buNone/>
              <a:defRPr sz="1300"/>
            </a:lvl2pPr>
            <a:lvl3pPr marL="995964" indent="0">
              <a:buNone/>
              <a:defRPr sz="1100"/>
            </a:lvl3pPr>
            <a:lvl4pPr marL="1493947" indent="0">
              <a:buNone/>
              <a:defRPr sz="1000"/>
            </a:lvl4pPr>
            <a:lvl5pPr marL="1991929" indent="0">
              <a:buNone/>
              <a:defRPr sz="1000"/>
            </a:lvl5pPr>
            <a:lvl6pPr marL="2489911" indent="0">
              <a:buNone/>
              <a:defRPr sz="1000"/>
            </a:lvl6pPr>
            <a:lvl7pPr marL="2987893" indent="0">
              <a:buNone/>
              <a:defRPr sz="1000"/>
            </a:lvl7pPr>
            <a:lvl8pPr marL="3485876" indent="0">
              <a:buNone/>
              <a:defRPr sz="1000"/>
            </a:lvl8pPr>
            <a:lvl9pPr marL="3983858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5D40C-A8DC-479A-A5D3-E7B4936A184B}" type="datetimeFigureOut">
              <a:rPr lang="en-GB" smtClean="0"/>
              <a:t>15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35FAC-C7EA-4164-B888-497B3F49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62714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908" y="302865"/>
            <a:ext cx="9628347" cy="1260475"/>
          </a:xfrm>
          <a:prstGeom prst="rect">
            <a:avLst/>
          </a:prstGeom>
        </p:spPr>
        <p:txBody>
          <a:bodyPr vert="horz" lIns="99596" tIns="49798" rIns="99596" bIns="49798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908" y="1764667"/>
            <a:ext cx="9628347" cy="4991131"/>
          </a:xfrm>
          <a:prstGeom prst="rect">
            <a:avLst/>
          </a:prstGeom>
        </p:spPr>
        <p:txBody>
          <a:bodyPr vert="horz" lIns="99596" tIns="49798" rIns="99596" bIns="49798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908" y="7009644"/>
            <a:ext cx="2496238" cy="402652"/>
          </a:xfrm>
          <a:prstGeom prst="rect">
            <a:avLst/>
          </a:prstGeom>
        </p:spPr>
        <p:txBody>
          <a:bodyPr vert="horz" lIns="99596" tIns="49798" rIns="99596" bIns="49798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A5D40C-A8DC-479A-A5D3-E7B4936A184B}" type="datetimeFigureOut">
              <a:rPr lang="en-GB" smtClean="0"/>
              <a:t>15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55206" y="7009644"/>
            <a:ext cx="3387752" cy="402652"/>
          </a:xfrm>
          <a:prstGeom prst="rect">
            <a:avLst/>
          </a:prstGeom>
        </p:spPr>
        <p:txBody>
          <a:bodyPr vert="horz" lIns="99596" tIns="49798" rIns="99596" bIns="49798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67017" y="7009644"/>
            <a:ext cx="2496238" cy="402652"/>
          </a:xfrm>
          <a:prstGeom prst="rect">
            <a:avLst/>
          </a:prstGeom>
        </p:spPr>
        <p:txBody>
          <a:bodyPr vert="horz" lIns="99596" tIns="49798" rIns="99596" bIns="49798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235FAC-C7EA-4164-B888-497B3F49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6274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95964" rtl="0" eaLnBrk="1" latinLnBrk="0" hangingPunct="1">
        <a:spcBef>
          <a:spcPct val="0"/>
        </a:spcBef>
        <a:buNone/>
        <a:defRPr sz="4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73487" indent="-373487" algn="l" defTabSz="995964" rtl="0" eaLnBrk="1" latinLnBrk="0" hangingPunct="1">
        <a:spcBef>
          <a:spcPct val="20000"/>
        </a:spcBef>
        <a:buFont typeface="Arial" panose="020B0604020202020204" pitchFamily="34" charset="0"/>
        <a:buChar char="•"/>
        <a:defRPr sz="3500" kern="1200">
          <a:solidFill>
            <a:schemeClr val="tx1"/>
          </a:solidFill>
          <a:latin typeface="+mn-lt"/>
          <a:ea typeface="+mn-ea"/>
          <a:cs typeface="+mn-cs"/>
        </a:defRPr>
      </a:lvl1pPr>
      <a:lvl2pPr marL="809221" indent="-311239" algn="l" defTabSz="995964" rtl="0" eaLnBrk="1" latinLnBrk="0" hangingPunct="1">
        <a:spcBef>
          <a:spcPct val="20000"/>
        </a:spcBef>
        <a:buFont typeface="Arial" panose="020B0604020202020204" pitchFamily="34" charset="0"/>
        <a:buChar char="–"/>
        <a:defRPr sz="3000" kern="1200">
          <a:solidFill>
            <a:schemeClr val="tx1"/>
          </a:solidFill>
          <a:latin typeface="+mn-lt"/>
          <a:ea typeface="+mn-ea"/>
          <a:cs typeface="+mn-cs"/>
        </a:defRPr>
      </a:lvl2pPr>
      <a:lvl3pPr marL="1244956" indent="-248991" algn="l" defTabSz="995964" rtl="0" eaLnBrk="1" latinLnBrk="0" hangingPunct="1">
        <a:spcBef>
          <a:spcPct val="2000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742938" indent="-248991" algn="l" defTabSz="995964" rtl="0" eaLnBrk="1" latinLnBrk="0" hangingPunct="1">
        <a:spcBef>
          <a:spcPct val="20000"/>
        </a:spcBef>
        <a:buFont typeface="Arial" panose="020B0604020202020204" pitchFamily="34" charset="0"/>
        <a:buChar char="–"/>
        <a:defRPr sz="2200" kern="1200">
          <a:solidFill>
            <a:schemeClr val="tx1"/>
          </a:solidFill>
          <a:latin typeface="+mn-lt"/>
          <a:ea typeface="+mn-ea"/>
          <a:cs typeface="+mn-cs"/>
        </a:defRPr>
      </a:lvl4pPr>
      <a:lvl5pPr marL="2240920" indent="-248991" algn="l" defTabSz="995964" rtl="0" eaLnBrk="1" latinLnBrk="0" hangingPunct="1">
        <a:spcBef>
          <a:spcPct val="20000"/>
        </a:spcBef>
        <a:buFont typeface="Arial" panose="020B0604020202020204" pitchFamily="34" charset="0"/>
        <a:buChar char="»"/>
        <a:defRPr sz="2200" kern="1200">
          <a:solidFill>
            <a:schemeClr val="tx1"/>
          </a:solidFill>
          <a:latin typeface="+mn-lt"/>
          <a:ea typeface="+mn-ea"/>
          <a:cs typeface="+mn-cs"/>
        </a:defRPr>
      </a:lvl5pPr>
      <a:lvl6pPr marL="2738902" indent="-248991" algn="l" defTabSz="995964" rtl="0" eaLnBrk="1" latinLnBrk="0" hangingPunct="1">
        <a:spcBef>
          <a:spcPct val="2000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6pPr>
      <a:lvl7pPr marL="3236885" indent="-248991" algn="l" defTabSz="995964" rtl="0" eaLnBrk="1" latinLnBrk="0" hangingPunct="1">
        <a:spcBef>
          <a:spcPct val="2000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7pPr>
      <a:lvl8pPr marL="3734867" indent="-248991" algn="l" defTabSz="995964" rtl="0" eaLnBrk="1" latinLnBrk="0" hangingPunct="1">
        <a:spcBef>
          <a:spcPct val="2000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8pPr>
      <a:lvl9pPr marL="4232849" indent="-248991" algn="l" defTabSz="995964" rtl="0" eaLnBrk="1" latinLnBrk="0" hangingPunct="1">
        <a:spcBef>
          <a:spcPct val="2000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596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497982" algn="l" defTabSz="99596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995964" algn="l" defTabSz="99596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493947" algn="l" defTabSz="99596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991929" algn="l" defTabSz="99596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489911" algn="l" defTabSz="99596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87893" algn="l" defTabSz="99596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85876" algn="l" defTabSz="99596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983858" algn="l" defTabSz="99596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p1"/>
          <p:cNvGrpSpPr/>
          <p:nvPr/>
        </p:nvGrpSpPr>
        <p:grpSpPr>
          <a:xfrm>
            <a:off x="1005681" y="885825"/>
            <a:ext cx="8546741" cy="5791200"/>
            <a:chOff x="2148681" y="1495425"/>
            <a:chExt cx="6561256" cy="4572000"/>
          </a:xfrm>
        </p:grpSpPr>
        <p:sp>
          <p:nvSpPr>
            <p:cNvPr id="3" name="rc3"/>
            <p:cNvSpPr/>
            <p:nvPr/>
          </p:nvSpPr>
          <p:spPr>
            <a:xfrm>
              <a:off x="2148681" y="1495425"/>
              <a:ext cx="6400800" cy="4572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" name="rc4"/>
            <p:cNvSpPr/>
            <p:nvPr/>
          </p:nvSpPr>
          <p:spPr>
            <a:xfrm>
              <a:off x="2148681" y="1915412"/>
              <a:ext cx="3200399" cy="207600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4782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" name="rc5"/>
            <p:cNvSpPr/>
            <p:nvPr/>
          </p:nvSpPr>
          <p:spPr>
            <a:xfrm>
              <a:off x="2622234" y="2241272"/>
              <a:ext cx="2650932" cy="127443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6" name="pl6"/>
            <p:cNvSpPr/>
            <p:nvPr/>
          </p:nvSpPr>
          <p:spPr>
            <a:xfrm>
              <a:off x="2742731" y="2897433"/>
              <a:ext cx="2409938" cy="255573"/>
            </a:xfrm>
            <a:custGeom>
              <a:avLst/>
              <a:gdLst/>
              <a:ahLst/>
              <a:cxnLst/>
              <a:rect l="0" t="0" r="0" b="0"/>
              <a:pathLst>
                <a:path w="2409938" h="255573">
                  <a:moveTo>
                    <a:pt x="0" y="255573"/>
                  </a:moveTo>
                  <a:lnTo>
                    <a:pt x="61793" y="216998"/>
                  </a:lnTo>
                  <a:lnTo>
                    <a:pt x="123586" y="179224"/>
                  </a:lnTo>
                  <a:lnTo>
                    <a:pt x="185379" y="143054"/>
                  </a:lnTo>
                  <a:lnTo>
                    <a:pt x="247173" y="109287"/>
                  </a:lnTo>
                  <a:lnTo>
                    <a:pt x="308966" y="78727"/>
                  </a:lnTo>
                  <a:lnTo>
                    <a:pt x="370759" y="52174"/>
                  </a:lnTo>
                  <a:lnTo>
                    <a:pt x="432553" y="30430"/>
                  </a:lnTo>
                  <a:lnTo>
                    <a:pt x="494346" y="14296"/>
                  </a:lnTo>
                  <a:lnTo>
                    <a:pt x="556139" y="4312"/>
                  </a:lnTo>
                  <a:lnTo>
                    <a:pt x="617932" y="0"/>
                  </a:lnTo>
                  <a:lnTo>
                    <a:pt x="679726" y="636"/>
                  </a:lnTo>
                  <a:lnTo>
                    <a:pt x="741519" y="5498"/>
                  </a:lnTo>
                  <a:lnTo>
                    <a:pt x="803312" y="13862"/>
                  </a:lnTo>
                  <a:lnTo>
                    <a:pt x="865106" y="25006"/>
                  </a:lnTo>
                  <a:lnTo>
                    <a:pt x="926899" y="38206"/>
                  </a:lnTo>
                  <a:lnTo>
                    <a:pt x="988692" y="52739"/>
                  </a:lnTo>
                  <a:lnTo>
                    <a:pt x="1050485" y="67882"/>
                  </a:lnTo>
                  <a:lnTo>
                    <a:pt x="1112279" y="82912"/>
                  </a:lnTo>
                  <a:lnTo>
                    <a:pt x="1174072" y="97105"/>
                  </a:lnTo>
                  <a:lnTo>
                    <a:pt x="1235865" y="109757"/>
                  </a:lnTo>
                  <a:lnTo>
                    <a:pt x="1297659" y="120565"/>
                  </a:lnTo>
                  <a:lnTo>
                    <a:pt x="1359452" y="129611"/>
                  </a:lnTo>
                  <a:lnTo>
                    <a:pt x="1421245" y="136992"/>
                  </a:lnTo>
                  <a:lnTo>
                    <a:pt x="1483038" y="142808"/>
                  </a:lnTo>
                  <a:lnTo>
                    <a:pt x="1544832" y="147155"/>
                  </a:lnTo>
                  <a:lnTo>
                    <a:pt x="1606625" y="150132"/>
                  </a:lnTo>
                  <a:lnTo>
                    <a:pt x="1668418" y="151836"/>
                  </a:lnTo>
                  <a:lnTo>
                    <a:pt x="1730212" y="152366"/>
                  </a:lnTo>
                  <a:lnTo>
                    <a:pt x="1792005" y="151819"/>
                  </a:lnTo>
                  <a:lnTo>
                    <a:pt x="1853798" y="150293"/>
                  </a:lnTo>
                  <a:lnTo>
                    <a:pt x="1915591" y="147886"/>
                  </a:lnTo>
                  <a:lnTo>
                    <a:pt x="1977385" y="144696"/>
                  </a:lnTo>
                  <a:lnTo>
                    <a:pt x="2039178" y="140821"/>
                  </a:lnTo>
                  <a:lnTo>
                    <a:pt x="2100971" y="136358"/>
                  </a:lnTo>
                  <a:lnTo>
                    <a:pt x="2162765" y="131406"/>
                  </a:lnTo>
                  <a:lnTo>
                    <a:pt x="2224558" y="126062"/>
                  </a:lnTo>
                  <a:lnTo>
                    <a:pt x="2286351" y="120425"/>
                  </a:lnTo>
                  <a:lnTo>
                    <a:pt x="2348144" y="114592"/>
                  </a:lnTo>
                  <a:lnTo>
                    <a:pt x="2409938" y="108661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" name="pt7"/>
            <p:cNvSpPr/>
            <p:nvPr/>
          </p:nvSpPr>
          <p:spPr>
            <a:xfrm>
              <a:off x="2724680" y="339585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" name="pt8"/>
            <p:cNvSpPr/>
            <p:nvPr/>
          </p:nvSpPr>
          <p:spPr>
            <a:xfrm>
              <a:off x="2742285" y="270739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" name="pt9"/>
            <p:cNvSpPr/>
            <p:nvPr/>
          </p:nvSpPr>
          <p:spPr>
            <a:xfrm>
              <a:off x="2760187" y="325050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" name="pt10"/>
            <p:cNvSpPr/>
            <p:nvPr/>
          </p:nvSpPr>
          <p:spPr>
            <a:xfrm>
              <a:off x="2778336" y="324989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" name="pt11"/>
            <p:cNvSpPr/>
            <p:nvPr/>
          </p:nvSpPr>
          <p:spPr>
            <a:xfrm>
              <a:off x="2796674" y="2734426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" name="pt12"/>
            <p:cNvSpPr/>
            <p:nvPr/>
          </p:nvSpPr>
          <p:spPr>
            <a:xfrm>
              <a:off x="2815206" y="271036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" name="pt13"/>
            <p:cNvSpPr/>
            <p:nvPr/>
          </p:nvSpPr>
          <p:spPr>
            <a:xfrm>
              <a:off x="2834006" y="3362850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" name="pt14"/>
            <p:cNvSpPr/>
            <p:nvPr/>
          </p:nvSpPr>
          <p:spPr>
            <a:xfrm>
              <a:off x="2852805" y="338875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" name="pt15"/>
            <p:cNvSpPr/>
            <p:nvPr/>
          </p:nvSpPr>
          <p:spPr>
            <a:xfrm>
              <a:off x="2871880" y="3392788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" name="pt16"/>
            <p:cNvSpPr/>
            <p:nvPr/>
          </p:nvSpPr>
          <p:spPr>
            <a:xfrm>
              <a:off x="2891027" y="271251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" name="pt17"/>
            <p:cNvSpPr/>
            <p:nvPr/>
          </p:nvSpPr>
          <p:spPr>
            <a:xfrm>
              <a:off x="2910316" y="2732562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" name="pt18"/>
            <p:cNvSpPr/>
            <p:nvPr/>
          </p:nvSpPr>
          <p:spPr>
            <a:xfrm>
              <a:off x="2929679" y="3290640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" name="pt19"/>
            <p:cNvSpPr/>
            <p:nvPr/>
          </p:nvSpPr>
          <p:spPr>
            <a:xfrm>
              <a:off x="2949883" y="273778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" name="pt20"/>
            <p:cNvSpPr/>
            <p:nvPr/>
          </p:nvSpPr>
          <p:spPr>
            <a:xfrm>
              <a:off x="2970413" y="327539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" name="pt21"/>
            <p:cNvSpPr/>
            <p:nvPr/>
          </p:nvSpPr>
          <p:spPr>
            <a:xfrm>
              <a:off x="2991720" y="273907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" name="pt22"/>
            <p:cNvSpPr/>
            <p:nvPr/>
          </p:nvSpPr>
          <p:spPr>
            <a:xfrm>
              <a:off x="3013208" y="2281150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" name="pt23"/>
            <p:cNvSpPr/>
            <p:nvPr/>
          </p:nvSpPr>
          <p:spPr>
            <a:xfrm>
              <a:off x="3034696" y="339465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" name="pt24"/>
            <p:cNvSpPr/>
            <p:nvPr/>
          </p:nvSpPr>
          <p:spPr>
            <a:xfrm>
              <a:off x="3056184" y="2719638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5" name="pt25"/>
            <p:cNvSpPr/>
            <p:nvPr/>
          </p:nvSpPr>
          <p:spPr>
            <a:xfrm>
              <a:off x="3078145" y="3055000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" name="pt26"/>
            <p:cNvSpPr/>
            <p:nvPr/>
          </p:nvSpPr>
          <p:spPr>
            <a:xfrm>
              <a:off x="3100302" y="3386582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" name="pt27"/>
            <p:cNvSpPr/>
            <p:nvPr/>
          </p:nvSpPr>
          <p:spPr>
            <a:xfrm>
              <a:off x="3122864" y="269553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" name="pt28"/>
            <p:cNvSpPr/>
            <p:nvPr/>
          </p:nvSpPr>
          <p:spPr>
            <a:xfrm>
              <a:off x="3145426" y="303727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" name="pt29"/>
            <p:cNvSpPr/>
            <p:nvPr/>
          </p:nvSpPr>
          <p:spPr>
            <a:xfrm>
              <a:off x="3168520" y="339639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" name="pt30"/>
            <p:cNvSpPr/>
            <p:nvPr/>
          </p:nvSpPr>
          <p:spPr>
            <a:xfrm>
              <a:off x="3168520" y="304392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" name="pt31"/>
            <p:cNvSpPr/>
            <p:nvPr/>
          </p:nvSpPr>
          <p:spPr>
            <a:xfrm>
              <a:off x="3217007" y="3375970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" name="pt32"/>
            <p:cNvSpPr/>
            <p:nvPr/>
          </p:nvSpPr>
          <p:spPr>
            <a:xfrm>
              <a:off x="3241621" y="273476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" name="pt33"/>
            <p:cNvSpPr/>
            <p:nvPr/>
          </p:nvSpPr>
          <p:spPr>
            <a:xfrm>
              <a:off x="3266883" y="306305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" name="pt34"/>
            <p:cNvSpPr/>
            <p:nvPr/>
          </p:nvSpPr>
          <p:spPr>
            <a:xfrm>
              <a:off x="3292145" y="273824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" name="pt35"/>
            <p:cNvSpPr/>
            <p:nvPr/>
          </p:nvSpPr>
          <p:spPr>
            <a:xfrm>
              <a:off x="3317956" y="270178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6" name="pt36"/>
            <p:cNvSpPr/>
            <p:nvPr/>
          </p:nvSpPr>
          <p:spPr>
            <a:xfrm>
              <a:off x="3344344" y="291078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" name="pt37"/>
            <p:cNvSpPr/>
            <p:nvPr/>
          </p:nvSpPr>
          <p:spPr>
            <a:xfrm>
              <a:off x="3371494" y="270911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" name="pt38"/>
            <p:cNvSpPr/>
            <p:nvPr/>
          </p:nvSpPr>
          <p:spPr>
            <a:xfrm>
              <a:off x="3399126" y="233712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" name="pt39"/>
            <p:cNvSpPr/>
            <p:nvPr/>
          </p:nvSpPr>
          <p:spPr>
            <a:xfrm>
              <a:off x="3428508" y="264958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" name="pt40"/>
            <p:cNvSpPr/>
            <p:nvPr/>
          </p:nvSpPr>
          <p:spPr>
            <a:xfrm>
              <a:off x="3458268" y="299517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" name="pt41"/>
            <p:cNvSpPr/>
            <p:nvPr/>
          </p:nvSpPr>
          <p:spPr>
            <a:xfrm>
              <a:off x="3489446" y="332078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2" name="pt42"/>
            <p:cNvSpPr/>
            <p:nvPr/>
          </p:nvSpPr>
          <p:spPr>
            <a:xfrm>
              <a:off x="3520839" y="264127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3" name="pt43"/>
            <p:cNvSpPr/>
            <p:nvPr/>
          </p:nvSpPr>
          <p:spPr>
            <a:xfrm>
              <a:off x="3552673" y="233468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4" name="pt44"/>
            <p:cNvSpPr/>
            <p:nvPr/>
          </p:nvSpPr>
          <p:spPr>
            <a:xfrm>
              <a:off x="3586679" y="316013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5" name="pt45"/>
            <p:cNvSpPr/>
            <p:nvPr/>
          </p:nvSpPr>
          <p:spPr>
            <a:xfrm>
              <a:off x="3620684" y="264664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6" name="pt46"/>
            <p:cNvSpPr/>
            <p:nvPr/>
          </p:nvSpPr>
          <p:spPr>
            <a:xfrm>
              <a:off x="3655769" y="329585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7" name="pt47"/>
            <p:cNvSpPr/>
            <p:nvPr/>
          </p:nvSpPr>
          <p:spPr>
            <a:xfrm>
              <a:off x="3692935" y="296728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8" name="pt48"/>
            <p:cNvSpPr/>
            <p:nvPr/>
          </p:nvSpPr>
          <p:spPr>
            <a:xfrm>
              <a:off x="3734747" y="261458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9" name="pt49"/>
            <p:cNvSpPr/>
            <p:nvPr/>
          </p:nvSpPr>
          <p:spPr>
            <a:xfrm>
              <a:off x="3776559" y="326549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0" name="pt50"/>
            <p:cNvSpPr/>
            <p:nvPr/>
          </p:nvSpPr>
          <p:spPr>
            <a:xfrm>
              <a:off x="3820984" y="261709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1" name="pt51"/>
            <p:cNvSpPr/>
            <p:nvPr/>
          </p:nvSpPr>
          <p:spPr>
            <a:xfrm>
              <a:off x="3865882" y="327789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2" name="pt52"/>
            <p:cNvSpPr/>
            <p:nvPr/>
          </p:nvSpPr>
          <p:spPr>
            <a:xfrm>
              <a:off x="3912798" y="320154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3" name="pt53"/>
            <p:cNvSpPr/>
            <p:nvPr/>
          </p:nvSpPr>
          <p:spPr>
            <a:xfrm>
              <a:off x="3962540" y="3289442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4" name="pt54"/>
            <p:cNvSpPr/>
            <p:nvPr/>
          </p:nvSpPr>
          <p:spPr>
            <a:xfrm>
              <a:off x="4017659" y="2678350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5" name="pt55"/>
            <p:cNvSpPr/>
            <p:nvPr/>
          </p:nvSpPr>
          <p:spPr>
            <a:xfrm>
              <a:off x="4081528" y="3309296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6" name="pt56"/>
            <p:cNvSpPr/>
            <p:nvPr/>
          </p:nvSpPr>
          <p:spPr>
            <a:xfrm>
              <a:off x="4145397" y="300153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7" name="pt57"/>
            <p:cNvSpPr/>
            <p:nvPr/>
          </p:nvSpPr>
          <p:spPr>
            <a:xfrm>
              <a:off x="4216233" y="2662782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8" name="pt58"/>
            <p:cNvSpPr/>
            <p:nvPr/>
          </p:nvSpPr>
          <p:spPr>
            <a:xfrm>
              <a:off x="4288405" y="2652688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9" name="pt59"/>
            <p:cNvSpPr/>
            <p:nvPr/>
          </p:nvSpPr>
          <p:spPr>
            <a:xfrm>
              <a:off x="4363465" y="3319742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0" name="pt60"/>
            <p:cNvSpPr/>
            <p:nvPr/>
          </p:nvSpPr>
          <p:spPr>
            <a:xfrm>
              <a:off x="4440088" y="3346030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1" name="pt61"/>
            <p:cNvSpPr/>
            <p:nvPr/>
          </p:nvSpPr>
          <p:spPr>
            <a:xfrm>
              <a:off x="4523839" y="273173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2" name="pt62"/>
            <p:cNvSpPr/>
            <p:nvPr/>
          </p:nvSpPr>
          <p:spPr>
            <a:xfrm>
              <a:off x="4645134" y="318493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3" name="pt63"/>
            <p:cNvSpPr/>
            <p:nvPr/>
          </p:nvSpPr>
          <p:spPr>
            <a:xfrm>
              <a:off x="4766428" y="323146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4" name="pt64"/>
            <p:cNvSpPr/>
            <p:nvPr/>
          </p:nvSpPr>
          <p:spPr>
            <a:xfrm>
              <a:off x="4892388" y="268004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5" name="pt65"/>
            <p:cNvSpPr/>
            <p:nvPr/>
          </p:nvSpPr>
          <p:spPr>
            <a:xfrm>
              <a:off x="5134618" y="306411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6" name="pl66"/>
            <p:cNvSpPr/>
            <p:nvPr/>
          </p:nvSpPr>
          <p:spPr>
            <a:xfrm>
              <a:off x="2742731" y="2554411"/>
              <a:ext cx="2409938" cy="366168"/>
            </a:xfrm>
            <a:custGeom>
              <a:avLst/>
              <a:gdLst/>
              <a:ahLst/>
              <a:cxnLst/>
              <a:rect l="0" t="0" r="0" b="0"/>
              <a:pathLst>
                <a:path w="2409938" h="366168">
                  <a:moveTo>
                    <a:pt x="0" y="365270"/>
                  </a:moveTo>
                  <a:lnTo>
                    <a:pt x="61793" y="366168"/>
                  </a:lnTo>
                  <a:lnTo>
                    <a:pt x="123586" y="362580"/>
                  </a:lnTo>
                  <a:lnTo>
                    <a:pt x="185379" y="352077"/>
                  </a:lnTo>
                  <a:lnTo>
                    <a:pt x="247173" y="332380"/>
                  </a:lnTo>
                  <a:lnTo>
                    <a:pt x="308966" y="303839"/>
                  </a:lnTo>
                  <a:lnTo>
                    <a:pt x="370759" y="270937"/>
                  </a:lnTo>
                  <a:lnTo>
                    <a:pt x="432553" y="239913"/>
                  </a:lnTo>
                  <a:lnTo>
                    <a:pt x="494346" y="216011"/>
                  </a:lnTo>
                  <a:lnTo>
                    <a:pt x="556139" y="202307"/>
                  </a:lnTo>
                  <a:lnTo>
                    <a:pt x="617932" y="198407"/>
                  </a:lnTo>
                  <a:lnTo>
                    <a:pt x="679726" y="202541"/>
                  </a:lnTo>
                  <a:lnTo>
                    <a:pt x="741519" y="212416"/>
                  </a:lnTo>
                  <a:lnTo>
                    <a:pt x="803312" y="225429"/>
                  </a:lnTo>
                  <a:lnTo>
                    <a:pt x="865106" y="238968"/>
                  </a:lnTo>
                  <a:lnTo>
                    <a:pt x="926899" y="250910"/>
                  </a:lnTo>
                  <a:lnTo>
                    <a:pt x="988692" y="260133"/>
                  </a:lnTo>
                  <a:lnTo>
                    <a:pt x="1050485" y="266644"/>
                  </a:lnTo>
                  <a:lnTo>
                    <a:pt x="1112279" y="271219"/>
                  </a:lnTo>
                  <a:lnTo>
                    <a:pt x="1174072" y="274901"/>
                  </a:lnTo>
                  <a:lnTo>
                    <a:pt x="1235865" y="278647"/>
                  </a:lnTo>
                  <a:lnTo>
                    <a:pt x="1297659" y="283083"/>
                  </a:lnTo>
                  <a:lnTo>
                    <a:pt x="1359452" y="288382"/>
                  </a:lnTo>
                  <a:lnTo>
                    <a:pt x="1421245" y="294399"/>
                  </a:lnTo>
                  <a:lnTo>
                    <a:pt x="1483038" y="300744"/>
                  </a:lnTo>
                  <a:lnTo>
                    <a:pt x="1544832" y="306804"/>
                  </a:lnTo>
                  <a:lnTo>
                    <a:pt x="1606625" y="311751"/>
                  </a:lnTo>
                  <a:lnTo>
                    <a:pt x="1668418" y="314562"/>
                  </a:lnTo>
                  <a:lnTo>
                    <a:pt x="1730212" y="314085"/>
                  </a:lnTo>
                  <a:lnTo>
                    <a:pt x="1792005" y="309198"/>
                  </a:lnTo>
                  <a:lnTo>
                    <a:pt x="1853798" y="299015"/>
                  </a:lnTo>
                  <a:lnTo>
                    <a:pt x="1915591" y="283083"/>
                  </a:lnTo>
                  <a:lnTo>
                    <a:pt x="1977385" y="261432"/>
                  </a:lnTo>
                  <a:lnTo>
                    <a:pt x="2039178" y="234484"/>
                  </a:lnTo>
                  <a:lnTo>
                    <a:pt x="2100971" y="202891"/>
                  </a:lnTo>
                  <a:lnTo>
                    <a:pt x="2162765" y="167385"/>
                  </a:lnTo>
                  <a:lnTo>
                    <a:pt x="2224558" y="128692"/>
                  </a:lnTo>
                  <a:lnTo>
                    <a:pt x="2286351" y="87491"/>
                  </a:lnTo>
                  <a:lnTo>
                    <a:pt x="2348144" y="44405"/>
                  </a:lnTo>
                  <a:lnTo>
                    <a:pt x="2409938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7" name="pl67"/>
            <p:cNvSpPr/>
            <p:nvPr/>
          </p:nvSpPr>
          <p:spPr>
            <a:xfrm>
              <a:off x="2742731" y="3039035"/>
              <a:ext cx="2409938" cy="418743"/>
            </a:xfrm>
            <a:custGeom>
              <a:avLst/>
              <a:gdLst/>
              <a:ahLst/>
              <a:cxnLst/>
              <a:rect l="0" t="0" r="0" b="0"/>
              <a:pathLst>
                <a:path w="2409938" h="418743">
                  <a:moveTo>
                    <a:pt x="0" y="347295"/>
                  </a:moveTo>
                  <a:lnTo>
                    <a:pt x="61793" y="269247"/>
                  </a:lnTo>
                  <a:lnTo>
                    <a:pt x="123586" y="197288"/>
                  </a:lnTo>
                  <a:lnTo>
                    <a:pt x="185379" y="135449"/>
                  </a:lnTo>
                  <a:lnTo>
                    <a:pt x="247173" y="87614"/>
                  </a:lnTo>
                  <a:lnTo>
                    <a:pt x="308966" y="55035"/>
                  </a:lnTo>
                  <a:lnTo>
                    <a:pt x="370759" y="34831"/>
                  </a:lnTo>
                  <a:lnTo>
                    <a:pt x="432553" y="22367"/>
                  </a:lnTo>
                  <a:lnTo>
                    <a:pt x="494346" y="14002"/>
                  </a:lnTo>
                  <a:lnTo>
                    <a:pt x="556139" y="7737"/>
                  </a:lnTo>
                  <a:lnTo>
                    <a:pt x="617932" y="3012"/>
                  </a:lnTo>
                  <a:lnTo>
                    <a:pt x="679726" y="151"/>
                  </a:lnTo>
                  <a:lnTo>
                    <a:pt x="741519" y="0"/>
                  </a:lnTo>
                  <a:lnTo>
                    <a:pt x="803312" y="3716"/>
                  </a:lnTo>
                  <a:lnTo>
                    <a:pt x="865106" y="12464"/>
                  </a:lnTo>
                  <a:lnTo>
                    <a:pt x="926899" y="26922"/>
                  </a:lnTo>
                  <a:lnTo>
                    <a:pt x="988692" y="46765"/>
                  </a:lnTo>
                  <a:lnTo>
                    <a:pt x="1050485" y="70540"/>
                  </a:lnTo>
                  <a:lnTo>
                    <a:pt x="1112279" y="96024"/>
                  </a:lnTo>
                  <a:lnTo>
                    <a:pt x="1174072" y="120728"/>
                  </a:lnTo>
                  <a:lnTo>
                    <a:pt x="1235865" y="142286"/>
                  </a:lnTo>
                  <a:lnTo>
                    <a:pt x="1297659" y="159466"/>
                  </a:lnTo>
                  <a:lnTo>
                    <a:pt x="1359452" y="172259"/>
                  </a:lnTo>
                  <a:lnTo>
                    <a:pt x="1421245" y="181005"/>
                  </a:lnTo>
                  <a:lnTo>
                    <a:pt x="1483038" y="186292"/>
                  </a:lnTo>
                  <a:lnTo>
                    <a:pt x="1544832" y="188926"/>
                  </a:lnTo>
                  <a:lnTo>
                    <a:pt x="1606625" y="189933"/>
                  </a:lnTo>
                  <a:lnTo>
                    <a:pt x="1668418" y="190531"/>
                  </a:lnTo>
                  <a:lnTo>
                    <a:pt x="1730212" y="192067"/>
                  </a:lnTo>
                  <a:lnTo>
                    <a:pt x="1792005" y="195860"/>
                  </a:lnTo>
                  <a:lnTo>
                    <a:pt x="1853798" y="202990"/>
                  </a:lnTo>
                  <a:lnTo>
                    <a:pt x="1915591" y="214108"/>
                  </a:lnTo>
                  <a:lnTo>
                    <a:pt x="1977385" y="229379"/>
                  </a:lnTo>
                  <a:lnTo>
                    <a:pt x="2039178" y="248577"/>
                  </a:lnTo>
                  <a:lnTo>
                    <a:pt x="2100971" y="271245"/>
                  </a:lnTo>
                  <a:lnTo>
                    <a:pt x="2162765" y="296847"/>
                  </a:lnTo>
                  <a:lnTo>
                    <a:pt x="2224558" y="324853"/>
                  </a:lnTo>
                  <a:lnTo>
                    <a:pt x="2286351" y="354779"/>
                  </a:lnTo>
                  <a:lnTo>
                    <a:pt x="2348144" y="386199"/>
                  </a:lnTo>
                  <a:lnTo>
                    <a:pt x="2409938" y="418743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8" name="pl68"/>
            <p:cNvSpPr/>
            <p:nvPr/>
          </p:nvSpPr>
          <p:spPr>
            <a:xfrm>
              <a:off x="2622234" y="2241272"/>
              <a:ext cx="0" cy="1274435"/>
            </a:xfrm>
            <a:custGeom>
              <a:avLst/>
              <a:gdLst/>
              <a:ahLst/>
              <a:cxnLst/>
              <a:rect l="0" t="0" r="0" b="0"/>
              <a:pathLst>
                <a:path h="1274435">
                  <a:moveTo>
                    <a:pt x="0" y="1274435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9" name="tx69"/>
            <p:cNvSpPr/>
            <p:nvPr/>
          </p:nvSpPr>
          <p:spPr>
            <a:xfrm>
              <a:off x="2418402" y="3413434"/>
              <a:ext cx="135508" cy="10953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1</a:t>
              </a:r>
            </a:p>
          </p:txBody>
        </p:sp>
        <p:sp>
          <p:nvSpPr>
            <p:cNvPr id="70" name="tx70"/>
            <p:cNvSpPr/>
            <p:nvPr/>
          </p:nvSpPr>
          <p:spPr>
            <a:xfrm>
              <a:off x="2469152" y="3088143"/>
              <a:ext cx="84757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71" name="tx71"/>
            <p:cNvSpPr/>
            <p:nvPr/>
          </p:nvSpPr>
          <p:spPr>
            <a:xfrm>
              <a:off x="2469152" y="2766571"/>
              <a:ext cx="84757" cy="10953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72" name="tx72"/>
            <p:cNvSpPr/>
            <p:nvPr/>
          </p:nvSpPr>
          <p:spPr>
            <a:xfrm>
              <a:off x="2469152" y="2443140"/>
              <a:ext cx="84757" cy="10953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73" name="pl73"/>
            <p:cNvSpPr/>
            <p:nvPr/>
          </p:nvSpPr>
          <p:spPr>
            <a:xfrm>
              <a:off x="2584276" y="3468426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4" name="pl74"/>
            <p:cNvSpPr/>
            <p:nvPr/>
          </p:nvSpPr>
          <p:spPr>
            <a:xfrm>
              <a:off x="2584276" y="3144995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5" name="pl75"/>
            <p:cNvSpPr/>
            <p:nvPr/>
          </p:nvSpPr>
          <p:spPr>
            <a:xfrm>
              <a:off x="2584276" y="2821563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6" name="pl76"/>
            <p:cNvSpPr/>
            <p:nvPr/>
          </p:nvSpPr>
          <p:spPr>
            <a:xfrm>
              <a:off x="2584276" y="2498132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7" name="pl77"/>
            <p:cNvSpPr/>
            <p:nvPr/>
          </p:nvSpPr>
          <p:spPr>
            <a:xfrm>
              <a:off x="2622234" y="3515707"/>
              <a:ext cx="2650932" cy="0"/>
            </a:xfrm>
            <a:custGeom>
              <a:avLst/>
              <a:gdLst/>
              <a:ahLst/>
              <a:cxnLst/>
              <a:rect l="0" t="0" r="0" b="0"/>
              <a:pathLst>
                <a:path w="2650932">
                  <a:moveTo>
                    <a:pt x="0" y="0"/>
                  </a:moveTo>
                  <a:lnTo>
                    <a:pt x="2650932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8" name="pl78"/>
            <p:cNvSpPr/>
            <p:nvPr/>
          </p:nvSpPr>
          <p:spPr>
            <a:xfrm>
              <a:off x="2891543" y="3515707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9" name="pl79"/>
            <p:cNvSpPr/>
            <p:nvPr/>
          </p:nvSpPr>
          <p:spPr>
            <a:xfrm>
              <a:off x="3185793" y="3515707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0" name="pl80"/>
            <p:cNvSpPr/>
            <p:nvPr/>
          </p:nvSpPr>
          <p:spPr>
            <a:xfrm>
              <a:off x="3501753" y="3515707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1" name="pl81"/>
            <p:cNvSpPr/>
            <p:nvPr/>
          </p:nvSpPr>
          <p:spPr>
            <a:xfrm>
              <a:off x="3789281" y="3515707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2" name="pl82"/>
            <p:cNvSpPr/>
            <p:nvPr/>
          </p:nvSpPr>
          <p:spPr>
            <a:xfrm>
              <a:off x="4099861" y="3515707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3" name="pl83"/>
            <p:cNvSpPr/>
            <p:nvPr/>
          </p:nvSpPr>
          <p:spPr>
            <a:xfrm>
              <a:off x="4402970" y="3515707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4" name="pl84"/>
            <p:cNvSpPr/>
            <p:nvPr/>
          </p:nvSpPr>
          <p:spPr>
            <a:xfrm>
              <a:off x="4536278" y="3515707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5" name="pl85"/>
            <p:cNvSpPr/>
            <p:nvPr/>
          </p:nvSpPr>
          <p:spPr>
            <a:xfrm>
              <a:off x="5032198" y="3515707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6" name="tx86"/>
            <p:cNvSpPr/>
            <p:nvPr/>
          </p:nvSpPr>
          <p:spPr>
            <a:xfrm>
              <a:off x="2743236" y="3581724"/>
              <a:ext cx="296614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26</a:t>
              </a:r>
            </a:p>
          </p:txBody>
        </p:sp>
        <p:sp>
          <p:nvSpPr>
            <p:cNvPr id="87" name="tx87"/>
            <p:cNvSpPr/>
            <p:nvPr/>
          </p:nvSpPr>
          <p:spPr>
            <a:xfrm>
              <a:off x="3143414" y="3583585"/>
              <a:ext cx="84757" cy="10953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88" name="tx88"/>
            <p:cNvSpPr/>
            <p:nvPr/>
          </p:nvSpPr>
          <p:spPr>
            <a:xfrm>
              <a:off x="3395825" y="3583585"/>
              <a:ext cx="211856" cy="10953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.7</a:t>
              </a:r>
            </a:p>
          </p:txBody>
        </p:sp>
        <p:sp>
          <p:nvSpPr>
            <p:cNvPr id="89" name="tx89"/>
            <p:cNvSpPr/>
            <p:nvPr/>
          </p:nvSpPr>
          <p:spPr>
            <a:xfrm>
              <a:off x="3683352" y="3581650"/>
              <a:ext cx="211856" cy="11147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.3</a:t>
              </a:r>
            </a:p>
          </p:txBody>
        </p:sp>
        <p:sp>
          <p:nvSpPr>
            <p:cNvPr id="90" name="tx90"/>
            <p:cNvSpPr/>
            <p:nvPr/>
          </p:nvSpPr>
          <p:spPr>
            <a:xfrm>
              <a:off x="3993933" y="3581724"/>
              <a:ext cx="211856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.4</a:t>
              </a:r>
            </a:p>
          </p:txBody>
        </p:sp>
        <p:sp>
          <p:nvSpPr>
            <p:cNvPr id="91" name="tx91"/>
            <p:cNvSpPr/>
            <p:nvPr/>
          </p:nvSpPr>
          <p:spPr>
            <a:xfrm>
              <a:off x="4297042" y="3581724"/>
              <a:ext cx="211856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.8</a:t>
              </a:r>
            </a:p>
          </p:txBody>
        </p:sp>
        <p:sp>
          <p:nvSpPr>
            <p:cNvPr id="92" name="tx92"/>
            <p:cNvSpPr/>
            <p:nvPr/>
          </p:nvSpPr>
          <p:spPr>
            <a:xfrm>
              <a:off x="4451520" y="3581724"/>
              <a:ext cx="169515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93" name="tx93"/>
            <p:cNvSpPr/>
            <p:nvPr/>
          </p:nvSpPr>
          <p:spPr>
            <a:xfrm>
              <a:off x="4947440" y="3581724"/>
              <a:ext cx="169515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5</a:t>
              </a:r>
            </a:p>
          </p:txBody>
        </p:sp>
        <p:sp>
          <p:nvSpPr>
            <p:cNvPr id="94" name="tx94"/>
            <p:cNvSpPr/>
            <p:nvPr/>
          </p:nvSpPr>
          <p:spPr>
            <a:xfrm>
              <a:off x="3750149" y="3757571"/>
              <a:ext cx="395101" cy="1293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ime</a:t>
              </a:r>
            </a:p>
          </p:txBody>
        </p:sp>
        <p:sp>
          <p:nvSpPr>
            <p:cNvPr id="95" name="tx95"/>
            <p:cNvSpPr/>
            <p:nvPr/>
          </p:nvSpPr>
          <p:spPr>
            <a:xfrm rot="16200000">
              <a:off x="1603551" y="2718825"/>
              <a:ext cx="1472291" cy="30937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algn="ctr">
                <a:lnSpc>
                  <a:spcPts val="1400"/>
                </a:lnSpc>
              </a:pPr>
              <a:r>
                <a:rPr sz="14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Beta(t) for </a:t>
              </a:r>
              <a:r>
                <a:rPr lang="en-US" sz="14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Kubota water </a:t>
              </a:r>
              <a:endParaRPr lang="en-US" sz="1400" dirty="0" smtClean="0">
                <a:solidFill>
                  <a:srgbClr val="000000">
                    <a:alpha val="100000"/>
                  </a:srgbClr>
                </a:solidFill>
                <a:latin typeface="Arial"/>
                <a:cs typeface="Arial"/>
              </a:endParaRPr>
            </a:p>
            <a:p>
              <a:pPr algn="ctr">
                <a:lnSpc>
                  <a:spcPts val="1400"/>
                </a:lnSpc>
              </a:pPr>
              <a:r>
                <a:rPr lang="en-US" sz="1400" dirty="0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drinking </a:t>
              </a:r>
              <a:r>
                <a:rPr lang="en-US" sz="14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est</a:t>
              </a:r>
              <a:endParaRPr sz="1400" dirty="0">
                <a:solidFill>
                  <a:srgbClr val="000000">
                    <a:alpha val="100000"/>
                  </a:srgbClr>
                </a:solidFill>
                <a:latin typeface="Arial"/>
                <a:cs typeface="Arial"/>
              </a:endParaRPr>
            </a:p>
          </p:txBody>
        </p:sp>
        <p:sp>
          <p:nvSpPr>
            <p:cNvPr id="96" name="tx96"/>
            <p:cNvSpPr/>
            <p:nvPr/>
          </p:nvSpPr>
          <p:spPr>
            <a:xfrm>
              <a:off x="2222223" y="1974598"/>
              <a:ext cx="3287316" cy="18831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600" dirty="0" err="1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choenfeld</a:t>
              </a:r>
              <a:r>
                <a:rPr sz="16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 Individual Test p: 0.9337</a:t>
              </a:r>
            </a:p>
          </p:txBody>
        </p:sp>
        <p:sp>
          <p:nvSpPr>
            <p:cNvPr id="97" name="rc97"/>
            <p:cNvSpPr/>
            <p:nvPr/>
          </p:nvSpPr>
          <p:spPr>
            <a:xfrm>
              <a:off x="5349081" y="1915412"/>
              <a:ext cx="3200399" cy="207600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4782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8" name="rc98"/>
            <p:cNvSpPr/>
            <p:nvPr/>
          </p:nvSpPr>
          <p:spPr>
            <a:xfrm>
              <a:off x="5822634" y="2241272"/>
              <a:ext cx="2650932" cy="127443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9" name="pl99"/>
            <p:cNvSpPr/>
            <p:nvPr/>
          </p:nvSpPr>
          <p:spPr>
            <a:xfrm>
              <a:off x="5943131" y="2502834"/>
              <a:ext cx="2409938" cy="459414"/>
            </a:xfrm>
            <a:custGeom>
              <a:avLst/>
              <a:gdLst/>
              <a:ahLst/>
              <a:cxnLst/>
              <a:rect l="0" t="0" r="0" b="0"/>
              <a:pathLst>
                <a:path w="2409938" h="459414">
                  <a:moveTo>
                    <a:pt x="0" y="137003"/>
                  </a:moveTo>
                  <a:lnTo>
                    <a:pt x="61793" y="183171"/>
                  </a:lnTo>
                  <a:lnTo>
                    <a:pt x="123586" y="227907"/>
                  </a:lnTo>
                  <a:lnTo>
                    <a:pt x="185379" y="269780"/>
                  </a:lnTo>
                  <a:lnTo>
                    <a:pt x="247173" y="307358"/>
                  </a:lnTo>
                  <a:lnTo>
                    <a:pt x="308966" y="339209"/>
                  </a:lnTo>
                  <a:lnTo>
                    <a:pt x="370759" y="363902"/>
                  </a:lnTo>
                  <a:lnTo>
                    <a:pt x="432553" y="380005"/>
                  </a:lnTo>
                  <a:lnTo>
                    <a:pt x="494346" y="386086"/>
                  </a:lnTo>
                  <a:lnTo>
                    <a:pt x="556139" y="381237"/>
                  </a:lnTo>
                  <a:lnTo>
                    <a:pt x="617932" y="366575"/>
                  </a:lnTo>
                  <a:lnTo>
                    <a:pt x="679726" y="343708"/>
                  </a:lnTo>
                  <a:lnTo>
                    <a:pt x="741519" y="314241"/>
                  </a:lnTo>
                  <a:lnTo>
                    <a:pt x="803312" y="279783"/>
                  </a:lnTo>
                  <a:lnTo>
                    <a:pt x="865106" y="241941"/>
                  </a:lnTo>
                  <a:lnTo>
                    <a:pt x="926899" y="202321"/>
                  </a:lnTo>
                  <a:lnTo>
                    <a:pt x="988692" y="162531"/>
                  </a:lnTo>
                  <a:lnTo>
                    <a:pt x="1050485" y="124179"/>
                  </a:lnTo>
                  <a:lnTo>
                    <a:pt x="1112279" y="88871"/>
                  </a:lnTo>
                  <a:lnTo>
                    <a:pt x="1174072" y="58214"/>
                  </a:lnTo>
                  <a:lnTo>
                    <a:pt x="1235865" y="33771"/>
                  </a:lnTo>
                  <a:lnTo>
                    <a:pt x="1297659" y="16142"/>
                  </a:lnTo>
                  <a:lnTo>
                    <a:pt x="1359452" y="5006"/>
                  </a:lnTo>
                  <a:lnTo>
                    <a:pt x="1421245" y="0"/>
                  </a:lnTo>
                  <a:lnTo>
                    <a:pt x="1483038" y="764"/>
                  </a:lnTo>
                  <a:lnTo>
                    <a:pt x="1544832" y="6937"/>
                  </a:lnTo>
                  <a:lnTo>
                    <a:pt x="1606625" y="18160"/>
                  </a:lnTo>
                  <a:lnTo>
                    <a:pt x="1668418" y="34071"/>
                  </a:lnTo>
                  <a:lnTo>
                    <a:pt x="1730212" y="54309"/>
                  </a:lnTo>
                  <a:lnTo>
                    <a:pt x="1792005" y="78514"/>
                  </a:lnTo>
                  <a:lnTo>
                    <a:pt x="1853798" y="106326"/>
                  </a:lnTo>
                  <a:lnTo>
                    <a:pt x="1915591" y="137384"/>
                  </a:lnTo>
                  <a:lnTo>
                    <a:pt x="1977385" y="171326"/>
                  </a:lnTo>
                  <a:lnTo>
                    <a:pt x="2039178" y="207793"/>
                  </a:lnTo>
                  <a:lnTo>
                    <a:pt x="2100971" y="246424"/>
                  </a:lnTo>
                  <a:lnTo>
                    <a:pt x="2162765" y="286858"/>
                  </a:lnTo>
                  <a:lnTo>
                    <a:pt x="2224558" y="328735"/>
                  </a:lnTo>
                  <a:lnTo>
                    <a:pt x="2286351" y="371694"/>
                  </a:lnTo>
                  <a:lnTo>
                    <a:pt x="2348144" y="415373"/>
                  </a:lnTo>
                  <a:lnTo>
                    <a:pt x="2409938" y="459414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0" name="pt100"/>
            <p:cNvSpPr/>
            <p:nvPr/>
          </p:nvSpPr>
          <p:spPr>
            <a:xfrm>
              <a:off x="5925080" y="3153960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1" name="pt101"/>
            <p:cNvSpPr/>
            <p:nvPr/>
          </p:nvSpPr>
          <p:spPr>
            <a:xfrm>
              <a:off x="5942685" y="247959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2" name="pt102"/>
            <p:cNvSpPr/>
            <p:nvPr/>
          </p:nvSpPr>
          <p:spPr>
            <a:xfrm>
              <a:off x="5960587" y="2457532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3" name="pt103"/>
            <p:cNvSpPr/>
            <p:nvPr/>
          </p:nvSpPr>
          <p:spPr>
            <a:xfrm>
              <a:off x="5978736" y="246013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4" name="pt104"/>
            <p:cNvSpPr/>
            <p:nvPr/>
          </p:nvSpPr>
          <p:spPr>
            <a:xfrm>
              <a:off x="5997074" y="3151336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5" name="pt105"/>
            <p:cNvSpPr/>
            <p:nvPr/>
          </p:nvSpPr>
          <p:spPr>
            <a:xfrm>
              <a:off x="6015606" y="3231380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6" name="pt106"/>
            <p:cNvSpPr/>
            <p:nvPr/>
          </p:nvSpPr>
          <p:spPr>
            <a:xfrm>
              <a:off x="6034406" y="2503206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7" name="pt107"/>
            <p:cNvSpPr/>
            <p:nvPr/>
          </p:nvSpPr>
          <p:spPr>
            <a:xfrm>
              <a:off x="6053205" y="242641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8" name="pt108"/>
            <p:cNvSpPr/>
            <p:nvPr/>
          </p:nvSpPr>
          <p:spPr>
            <a:xfrm>
              <a:off x="6072280" y="242594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9" name="pt109"/>
            <p:cNvSpPr/>
            <p:nvPr/>
          </p:nvSpPr>
          <p:spPr>
            <a:xfrm>
              <a:off x="6091427" y="248826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0" name="pt110"/>
            <p:cNvSpPr/>
            <p:nvPr/>
          </p:nvSpPr>
          <p:spPr>
            <a:xfrm>
              <a:off x="6110716" y="241025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1" name="pt111"/>
            <p:cNvSpPr/>
            <p:nvPr/>
          </p:nvSpPr>
          <p:spPr>
            <a:xfrm>
              <a:off x="6130079" y="311308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2" name="pt112"/>
            <p:cNvSpPr/>
            <p:nvPr/>
          </p:nvSpPr>
          <p:spPr>
            <a:xfrm>
              <a:off x="6150283" y="240041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3" name="pt113"/>
            <p:cNvSpPr/>
            <p:nvPr/>
          </p:nvSpPr>
          <p:spPr>
            <a:xfrm>
              <a:off x="6170813" y="2384066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4" name="pt114"/>
            <p:cNvSpPr/>
            <p:nvPr/>
          </p:nvSpPr>
          <p:spPr>
            <a:xfrm>
              <a:off x="6192120" y="314729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5" name="pt115"/>
            <p:cNvSpPr/>
            <p:nvPr/>
          </p:nvSpPr>
          <p:spPr>
            <a:xfrm>
              <a:off x="6213608" y="2372198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6" name="pt116"/>
            <p:cNvSpPr/>
            <p:nvPr/>
          </p:nvSpPr>
          <p:spPr>
            <a:xfrm>
              <a:off x="6235096" y="315888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7" name="pt117"/>
            <p:cNvSpPr/>
            <p:nvPr/>
          </p:nvSpPr>
          <p:spPr>
            <a:xfrm>
              <a:off x="6256584" y="2410822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8" name="pt118"/>
            <p:cNvSpPr/>
            <p:nvPr/>
          </p:nvSpPr>
          <p:spPr>
            <a:xfrm>
              <a:off x="6278545" y="314932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9" name="pt119"/>
            <p:cNvSpPr/>
            <p:nvPr/>
          </p:nvSpPr>
          <p:spPr>
            <a:xfrm>
              <a:off x="6300702" y="316047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0" name="pt120"/>
            <p:cNvSpPr/>
            <p:nvPr/>
          </p:nvSpPr>
          <p:spPr>
            <a:xfrm>
              <a:off x="6323264" y="248716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1" name="pt121"/>
            <p:cNvSpPr/>
            <p:nvPr/>
          </p:nvSpPr>
          <p:spPr>
            <a:xfrm>
              <a:off x="6345826" y="3221906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2" name="pt122"/>
            <p:cNvSpPr/>
            <p:nvPr/>
          </p:nvSpPr>
          <p:spPr>
            <a:xfrm>
              <a:off x="6368920" y="314993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3" name="pt123"/>
            <p:cNvSpPr/>
            <p:nvPr/>
          </p:nvSpPr>
          <p:spPr>
            <a:xfrm>
              <a:off x="6368920" y="321987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4" name="pt124"/>
            <p:cNvSpPr/>
            <p:nvPr/>
          </p:nvSpPr>
          <p:spPr>
            <a:xfrm>
              <a:off x="6417407" y="248869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5" name="pt125"/>
            <p:cNvSpPr/>
            <p:nvPr/>
          </p:nvSpPr>
          <p:spPr>
            <a:xfrm>
              <a:off x="6442021" y="314219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6" name="pt126"/>
            <p:cNvSpPr/>
            <p:nvPr/>
          </p:nvSpPr>
          <p:spPr>
            <a:xfrm>
              <a:off x="6467283" y="315246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7" name="pt127"/>
            <p:cNvSpPr/>
            <p:nvPr/>
          </p:nvSpPr>
          <p:spPr>
            <a:xfrm>
              <a:off x="6492545" y="314995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8" name="pt128"/>
            <p:cNvSpPr/>
            <p:nvPr/>
          </p:nvSpPr>
          <p:spPr>
            <a:xfrm>
              <a:off x="6518356" y="3145792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9" name="pt129"/>
            <p:cNvSpPr/>
            <p:nvPr/>
          </p:nvSpPr>
          <p:spPr>
            <a:xfrm>
              <a:off x="6544744" y="237588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0" name="pt130"/>
            <p:cNvSpPr/>
            <p:nvPr/>
          </p:nvSpPr>
          <p:spPr>
            <a:xfrm>
              <a:off x="6571894" y="3141912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1" name="pt131"/>
            <p:cNvSpPr/>
            <p:nvPr/>
          </p:nvSpPr>
          <p:spPr>
            <a:xfrm>
              <a:off x="6599526" y="2465362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2" name="pt132"/>
            <p:cNvSpPr/>
            <p:nvPr/>
          </p:nvSpPr>
          <p:spPr>
            <a:xfrm>
              <a:off x="6628908" y="246262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3" name="pt133"/>
            <p:cNvSpPr/>
            <p:nvPr/>
          </p:nvSpPr>
          <p:spPr>
            <a:xfrm>
              <a:off x="6658668" y="314451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4" name="pt134"/>
            <p:cNvSpPr/>
            <p:nvPr/>
          </p:nvSpPr>
          <p:spPr>
            <a:xfrm>
              <a:off x="6689846" y="2412028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5" name="pt135"/>
            <p:cNvSpPr/>
            <p:nvPr/>
          </p:nvSpPr>
          <p:spPr>
            <a:xfrm>
              <a:off x="6721239" y="2469850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6" name="pt136"/>
            <p:cNvSpPr/>
            <p:nvPr/>
          </p:nvSpPr>
          <p:spPr>
            <a:xfrm>
              <a:off x="6753073" y="313688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7" name="pt137"/>
            <p:cNvSpPr/>
            <p:nvPr/>
          </p:nvSpPr>
          <p:spPr>
            <a:xfrm>
              <a:off x="6787079" y="246675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8" name="pt138"/>
            <p:cNvSpPr/>
            <p:nvPr/>
          </p:nvSpPr>
          <p:spPr>
            <a:xfrm>
              <a:off x="6821084" y="315149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9" name="pt139"/>
            <p:cNvSpPr/>
            <p:nvPr/>
          </p:nvSpPr>
          <p:spPr>
            <a:xfrm>
              <a:off x="6856169" y="2447016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0" name="pt140"/>
            <p:cNvSpPr/>
            <p:nvPr/>
          </p:nvSpPr>
          <p:spPr>
            <a:xfrm>
              <a:off x="6893335" y="240574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1" name="pt141"/>
            <p:cNvSpPr/>
            <p:nvPr/>
          </p:nvSpPr>
          <p:spPr>
            <a:xfrm>
              <a:off x="6935147" y="2463200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2" name="pt142"/>
            <p:cNvSpPr/>
            <p:nvPr/>
          </p:nvSpPr>
          <p:spPr>
            <a:xfrm>
              <a:off x="6976959" y="2464518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3" name="pt143"/>
            <p:cNvSpPr/>
            <p:nvPr/>
          </p:nvSpPr>
          <p:spPr>
            <a:xfrm>
              <a:off x="7021384" y="3190042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4" name="pt144"/>
            <p:cNvSpPr/>
            <p:nvPr/>
          </p:nvSpPr>
          <p:spPr>
            <a:xfrm>
              <a:off x="7066282" y="246775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5" name="pt145"/>
            <p:cNvSpPr/>
            <p:nvPr/>
          </p:nvSpPr>
          <p:spPr>
            <a:xfrm>
              <a:off x="7113198" y="234805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6" name="pt146"/>
            <p:cNvSpPr/>
            <p:nvPr/>
          </p:nvSpPr>
          <p:spPr>
            <a:xfrm>
              <a:off x="7162940" y="244004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7" name="pt147"/>
            <p:cNvSpPr/>
            <p:nvPr/>
          </p:nvSpPr>
          <p:spPr>
            <a:xfrm>
              <a:off x="7218059" y="235371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8" name="pt148"/>
            <p:cNvSpPr/>
            <p:nvPr/>
          </p:nvSpPr>
          <p:spPr>
            <a:xfrm>
              <a:off x="7281928" y="232394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9" name="pt149"/>
            <p:cNvSpPr/>
            <p:nvPr/>
          </p:nvSpPr>
          <p:spPr>
            <a:xfrm>
              <a:off x="7345797" y="230554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0" name="pt150"/>
            <p:cNvSpPr/>
            <p:nvPr/>
          </p:nvSpPr>
          <p:spPr>
            <a:xfrm>
              <a:off x="7416633" y="307840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1" name="pt151"/>
            <p:cNvSpPr/>
            <p:nvPr/>
          </p:nvSpPr>
          <p:spPr>
            <a:xfrm>
              <a:off x="7488805" y="3094920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2" name="pt152"/>
            <p:cNvSpPr/>
            <p:nvPr/>
          </p:nvSpPr>
          <p:spPr>
            <a:xfrm>
              <a:off x="7563865" y="231130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3" name="pt153"/>
            <p:cNvSpPr/>
            <p:nvPr/>
          </p:nvSpPr>
          <p:spPr>
            <a:xfrm>
              <a:off x="7640488" y="302941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4" name="pt154"/>
            <p:cNvSpPr/>
            <p:nvPr/>
          </p:nvSpPr>
          <p:spPr>
            <a:xfrm>
              <a:off x="7724239" y="239743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5" name="pt155"/>
            <p:cNvSpPr/>
            <p:nvPr/>
          </p:nvSpPr>
          <p:spPr>
            <a:xfrm>
              <a:off x="7845534" y="234993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6" name="pt156"/>
            <p:cNvSpPr/>
            <p:nvPr/>
          </p:nvSpPr>
          <p:spPr>
            <a:xfrm>
              <a:off x="7966828" y="2289866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7" name="pt157"/>
            <p:cNvSpPr/>
            <p:nvPr/>
          </p:nvSpPr>
          <p:spPr>
            <a:xfrm>
              <a:off x="8092788" y="246707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8" name="pt158"/>
            <p:cNvSpPr/>
            <p:nvPr/>
          </p:nvSpPr>
          <p:spPr>
            <a:xfrm>
              <a:off x="8335018" y="334248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9" name="pl159"/>
            <p:cNvSpPr/>
            <p:nvPr/>
          </p:nvSpPr>
          <p:spPr>
            <a:xfrm>
              <a:off x="5943131" y="2299201"/>
              <a:ext cx="2409938" cy="437136"/>
            </a:xfrm>
            <a:custGeom>
              <a:avLst/>
              <a:gdLst/>
              <a:ahLst/>
              <a:cxnLst/>
              <a:rect l="0" t="0" r="0" b="0"/>
              <a:pathLst>
                <a:path w="2409938" h="437136">
                  <a:moveTo>
                    <a:pt x="0" y="84663"/>
                  </a:moveTo>
                  <a:lnTo>
                    <a:pt x="61793" y="174135"/>
                  </a:lnTo>
                  <a:lnTo>
                    <a:pt x="123586" y="256376"/>
                  </a:lnTo>
                  <a:lnTo>
                    <a:pt x="185379" y="326408"/>
                  </a:lnTo>
                  <a:lnTo>
                    <a:pt x="247173" y="379420"/>
                  </a:lnTo>
                  <a:lnTo>
                    <a:pt x="308966" y="413487"/>
                  </a:lnTo>
                  <a:lnTo>
                    <a:pt x="370759" y="431214"/>
                  </a:lnTo>
                  <a:lnTo>
                    <a:pt x="432553" y="437136"/>
                  </a:lnTo>
                  <a:lnTo>
                    <a:pt x="494346" y="434695"/>
                  </a:lnTo>
                  <a:lnTo>
                    <a:pt x="556139" y="425765"/>
                  </a:lnTo>
                  <a:lnTo>
                    <a:pt x="617932" y="411556"/>
                  </a:lnTo>
                  <a:lnTo>
                    <a:pt x="679726" y="392525"/>
                  </a:lnTo>
                  <a:lnTo>
                    <a:pt x="741519" y="368558"/>
                  </a:lnTo>
                  <a:lnTo>
                    <a:pt x="803312" y="339200"/>
                  </a:lnTo>
                  <a:lnTo>
                    <a:pt x="865106" y="303986"/>
                  </a:lnTo>
                  <a:lnTo>
                    <a:pt x="926899" y="262986"/>
                  </a:lnTo>
                  <a:lnTo>
                    <a:pt x="988692" y="217371"/>
                  </a:lnTo>
                  <a:lnTo>
                    <a:pt x="1050485" y="169548"/>
                  </a:lnTo>
                  <a:lnTo>
                    <a:pt x="1112279" y="122771"/>
                  </a:lnTo>
                  <a:lnTo>
                    <a:pt x="1174072" y="80582"/>
                  </a:lnTo>
                  <a:lnTo>
                    <a:pt x="1235865" y="46369"/>
                  </a:lnTo>
                  <a:lnTo>
                    <a:pt x="1297659" y="21750"/>
                  </a:lnTo>
                  <a:lnTo>
                    <a:pt x="1359452" y="6503"/>
                  </a:lnTo>
                  <a:lnTo>
                    <a:pt x="1421245" y="0"/>
                  </a:lnTo>
                  <a:lnTo>
                    <a:pt x="1483038" y="1344"/>
                  </a:lnTo>
                  <a:lnTo>
                    <a:pt x="1544832" y="9397"/>
                  </a:lnTo>
                  <a:lnTo>
                    <a:pt x="1606625" y="22781"/>
                  </a:lnTo>
                  <a:lnTo>
                    <a:pt x="1668418" y="39905"/>
                  </a:lnTo>
                  <a:lnTo>
                    <a:pt x="1730212" y="59040"/>
                  </a:lnTo>
                  <a:lnTo>
                    <a:pt x="1792005" y="78484"/>
                  </a:lnTo>
                  <a:lnTo>
                    <a:pt x="1853798" y="96799"/>
                  </a:lnTo>
                  <a:lnTo>
                    <a:pt x="1915591" y="113018"/>
                  </a:lnTo>
                  <a:lnTo>
                    <a:pt x="1977385" y="126708"/>
                  </a:lnTo>
                  <a:lnTo>
                    <a:pt x="2039178" y="137863"/>
                  </a:lnTo>
                  <a:lnTo>
                    <a:pt x="2100971" y="146729"/>
                  </a:lnTo>
                  <a:lnTo>
                    <a:pt x="2162765" y="153643"/>
                  </a:lnTo>
                  <a:lnTo>
                    <a:pt x="2224558" y="158933"/>
                  </a:lnTo>
                  <a:lnTo>
                    <a:pt x="2286351" y="162876"/>
                  </a:lnTo>
                  <a:lnTo>
                    <a:pt x="2348144" y="165685"/>
                  </a:lnTo>
                  <a:lnTo>
                    <a:pt x="2409938" y="167517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0" name="pl160"/>
            <p:cNvSpPr/>
            <p:nvPr/>
          </p:nvSpPr>
          <p:spPr>
            <a:xfrm>
              <a:off x="5943131" y="2706468"/>
              <a:ext cx="2409938" cy="751310"/>
            </a:xfrm>
            <a:custGeom>
              <a:avLst/>
              <a:gdLst/>
              <a:ahLst/>
              <a:cxnLst/>
              <a:rect l="0" t="0" r="0" b="0"/>
              <a:pathLst>
                <a:path w="2409938" h="751310">
                  <a:moveTo>
                    <a:pt x="0" y="189344"/>
                  </a:moveTo>
                  <a:lnTo>
                    <a:pt x="61793" y="192207"/>
                  </a:lnTo>
                  <a:lnTo>
                    <a:pt x="123586" y="199439"/>
                  </a:lnTo>
                  <a:lnTo>
                    <a:pt x="185379" y="213152"/>
                  </a:lnTo>
                  <a:lnTo>
                    <a:pt x="247173" y="235295"/>
                  </a:lnTo>
                  <a:lnTo>
                    <a:pt x="308966" y="264932"/>
                  </a:lnTo>
                  <a:lnTo>
                    <a:pt x="370759" y="296590"/>
                  </a:lnTo>
                  <a:lnTo>
                    <a:pt x="432553" y="322874"/>
                  </a:lnTo>
                  <a:lnTo>
                    <a:pt x="494346" y="337477"/>
                  </a:lnTo>
                  <a:lnTo>
                    <a:pt x="556139" y="336709"/>
                  </a:lnTo>
                  <a:lnTo>
                    <a:pt x="617932" y="321595"/>
                  </a:lnTo>
                  <a:lnTo>
                    <a:pt x="679726" y="294890"/>
                  </a:lnTo>
                  <a:lnTo>
                    <a:pt x="741519" y="259924"/>
                  </a:lnTo>
                  <a:lnTo>
                    <a:pt x="803312" y="220366"/>
                  </a:lnTo>
                  <a:lnTo>
                    <a:pt x="865106" y="179896"/>
                  </a:lnTo>
                  <a:lnTo>
                    <a:pt x="926899" y="141656"/>
                  </a:lnTo>
                  <a:lnTo>
                    <a:pt x="988692" y="107692"/>
                  </a:lnTo>
                  <a:lnTo>
                    <a:pt x="1050485" y="78809"/>
                  </a:lnTo>
                  <a:lnTo>
                    <a:pt x="1112279" y="54970"/>
                  </a:lnTo>
                  <a:lnTo>
                    <a:pt x="1174072" y="35845"/>
                  </a:lnTo>
                  <a:lnTo>
                    <a:pt x="1235865" y="21173"/>
                  </a:lnTo>
                  <a:lnTo>
                    <a:pt x="1297659" y="10535"/>
                  </a:lnTo>
                  <a:lnTo>
                    <a:pt x="1359452" y="3509"/>
                  </a:lnTo>
                  <a:lnTo>
                    <a:pt x="1421245" y="0"/>
                  </a:lnTo>
                  <a:lnTo>
                    <a:pt x="1483038" y="183"/>
                  </a:lnTo>
                  <a:lnTo>
                    <a:pt x="1544832" y="4478"/>
                  </a:lnTo>
                  <a:lnTo>
                    <a:pt x="1606625" y="13539"/>
                  </a:lnTo>
                  <a:lnTo>
                    <a:pt x="1668418" y="28236"/>
                  </a:lnTo>
                  <a:lnTo>
                    <a:pt x="1730212" y="49578"/>
                  </a:lnTo>
                  <a:lnTo>
                    <a:pt x="1792005" y="78545"/>
                  </a:lnTo>
                  <a:lnTo>
                    <a:pt x="1853798" y="115854"/>
                  </a:lnTo>
                  <a:lnTo>
                    <a:pt x="1915591" y="161749"/>
                  </a:lnTo>
                  <a:lnTo>
                    <a:pt x="1977385" y="215945"/>
                  </a:lnTo>
                  <a:lnTo>
                    <a:pt x="2039178" y="277724"/>
                  </a:lnTo>
                  <a:lnTo>
                    <a:pt x="2100971" y="346120"/>
                  </a:lnTo>
                  <a:lnTo>
                    <a:pt x="2162765" y="420074"/>
                  </a:lnTo>
                  <a:lnTo>
                    <a:pt x="2224558" y="498537"/>
                  </a:lnTo>
                  <a:lnTo>
                    <a:pt x="2286351" y="580511"/>
                  </a:lnTo>
                  <a:lnTo>
                    <a:pt x="2348144" y="665061"/>
                  </a:lnTo>
                  <a:lnTo>
                    <a:pt x="2409938" y="75131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1" name="pl161"/>
            <p:cNvSpPr/>
            <p:nvPr/>
          </p:nvSpPr>
          <p:spPr>
            <a:xfrm>
              <a:off x="5822634" y="2241272"/>
              <a:ext cx="0" cy="1274435"/>
            </a:xfrm>
            <a:custGeom>
              <a:avLst/>
              <a:gdLst/>
              <a:ahLst/>
              <a:cxnLst/>
              <a:rect l="0" t="0" r="0" b="0"/>
              <a:pathLst>
                <a:path h="1274435">
                  <a:moveTo>
                    <a:pt x="0" y="1274435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2" name="tx162"/>
            <p:cNvSpPr/>
            <p:nvPr/>
          </p:nvSpPr>
          <p:spPr>
            <a:xfrm>
              <a:off x="5618802" y="3154870"/>
              <a:ext cx="135508" cy="10953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2</a:t>
              </a:r>
            </a:p>
          </p:txBody>
        </p:sp>
        <p:sp>
          <p:nvSpPr>
            <p:cNvPr id="163" name="tx163"/>
            <p:cNvSpPr/>
            <p:nvPr/>
          </p:nvSpPr>
          <p:spPr>
            <a:xfrm>
              <a:off x="5669552" y="2804532"/>
              <a:ext cx="84757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64" name="tx164"/>
            <p:cNvSpPr/>
            <p:nvPr/>
          </p:nvSpPr>
          <p:spPr>
            <a:xfrm>
              <a:off x="5669552" y="2457915"/>
              <a:ext cx="84757" cy="10953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165" name="pl165"/>
            <p:cNvSpPr/>
            <p:nvPr/>
          </p:nvSpPr>
          <p:spPr>
            <a:xfrm>
              <a:off x="5784676" y="3209862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6" name="pl166"/>
            <p:cNvSpPr/>
            <p:nvPr/>
          </p:nvSpPr>
          <p:spPr>
            <a:xfrm>
              <a:off x="5784676" y="2861384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7" name="pl167"/>
            <p:cNvSpPr/>
            <p:nvPr/>
          </p:nvSpPr>
          <p:spPr>
            <a:xfrm>
              <a:off x="5784676" y="2512907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8" name="pl168"/>
            <p:cNvSpPr/>
            <p:nvPr/>
          </p:nvSpPr>
          <p:spPr>
            <a:xfrm>
              <a:off x="5822634" y="3515707"/>
              <a:ext cx="2650932" cy="0"/>
            </a:xfrm>
            <a:custGeom>
              <a:avLst/>
              <a:gdLst/>
              <a:ahLst/>
              <a:cxnLst/>
              <a:rect l="0" t="0" r="0" b="0"/>
              <a:pathLst>
                <a:path w="2650932">
                  <a:moveTo>
                    <a:pt x="0" y="0"/>
                  </a:moveTo>
                  <a:lnTo>
                    <a:pt x="2650932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9" name="pl169"/>
            <p:cNvSpPr/>
            <p:nvPr/>
          </p:nvSpPr>
          <p:spPr>
            <a:xfrm>
              <a:off x="6091943" y="3515707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0" name="pl170"/>
            <p:cNvSpPr/>
            <p:nvPr/>
          </p:nvSpPr>
          <p:spPr>
            <a:xfrm>
              <a:off x="6386193" y="3515707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1" name="pl171"/>
            <p:cNvSpPr/>
            <p:nvPr/>
          </p:nvSpPr>
          <p:spPr>
            <a:xfrm>
              <a:off x="6702153" y="3515707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2" name="pl172"/>
            <p:cNvSpPr/>
            <p:nvPr/>
          </p:nvSpPr>
          <p:spPr>
            <a:xfrm>
              <a:off x="6989681" y="3515707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3" name="pl173"/>
            <p:cNvSpPr/>
            <p:nvPr/>
          </p:nvSpPr>
          <p:spPr>
            <a:xfrm>
              <a:off x="7300261" y="3515707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4" name="pl174"/>
            <p:cNvSpPr/>
            <p:nvPr/>
          </p:nvSpPr>
          <p:spPr>
            <a:xfrm>
              <a:off x="7603370" y="3515707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5" name="pl175"/>
            <p:cNvSpPr/>
            <p:nvPr/>
          </p:nvSpPr>
          <p:spPr>
            <a:xfrm>
              <a:off x="7736678" y="3515707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6" name="pl176"/>
            <p:cNvSpPr/>
            <p:nvPr/>
          </p:nvSpPr>
          <p:spPr>
            <a:xfrm>
              <a:off x="8232598" y="3515707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7" name="tx177"/>
            <p:cNvSpPr/>
            <p:nvPr/>
          </p:nvSpPr>
          <p:spPr>
            <a:xfrm>
              <a:off x="5943636" y="3581724"/>
              <a:ext cx="296614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26</a:t>
              </a:r>
            </a:p>
          </p:txBody>
        </p:sp>
        <p:sp>
          <p:nvSpPr>
            <p:cNvPr id="178" name="tx178"/>
            <p:cNvSpPr/>
            <p:nvPr/>
          </p:nvSpPr>
          <p:spPr>
            <a:xfrm>
              <a:off x="6343814" y="3583585"/>
              <a:ext cx="84757" cy="10953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179" name="tx179"/>
            <p:cNvSpPr/>
            <p:nvPr/>
          </p:nvSpPr>
          <p:spPr>
            <a:xfrm>
              <a:off x="6596225" y="3583585"/>
              <a:ext cx="211856" cy="10953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.7</a:t>
              </a:r>
            </a:p>
          </p:txBody>
        </p:sp>
        <p:sp>
          <p:nvSpPr>
            <p:cNvPr id="180" name="tx180"/>
            <p:cNvSpPr/>
            <p:nvPr/>
          </p:nvSpPr>
          <p:spPr>
            <a:xfrm>
              <a:off x="6883752" y="3581650"/>
              <a:ext cx="211856" cy="11147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.3</a:t>
              </a:r>
            </a:p>
          </p:txBody>
        </p:sp>
        <p:sp>
          <p:nvSpPr>
            <p:cNvPr id="181" name="tx181"/>
            <p:cNvSpPr/>
            <p:nvPr/>
          </p:nvSpPr>
          <p:spPr>
            <a:xfrm>
              <a:off x="7194333" y="3581724"/>
              <a:ext cx="211856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.4</a:t>
              </a:r>
            </a:p>
          </p:txBody>
        </p:sp>
        <p:sp>
          <p:nvSpPr>
            <p:cNvPr id="182" name="tx182"/>
            <p:cNvSpPr/>
            <p:nvPr/>
          </p:nvSpPr>
          <p:spPr>
            <a:xfrm>
              <a:off x="7497442" y="3581724"/>
              <a:ext cx="211856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.8</a:t>
              </a:r>
            </a:p>
          </p:txBody>
        </p:sp>
        <p:sp>
          <p:nvSpPr>
            <p:cNvPr id="183" name="tx183"/>
            <p:cNvSpPr/>
            <p:nvPr/>
          </p:nvSpPr>
          <p:spPr>
            <a:xfrm>
              <a:off x="7651920" y="3581724"/>
              <a:ext cx="169515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184" name="tx184"/>
            <p:cNvSpPr/>
            <p:nvPr/>
          </p:nvSpPr>
          <p:spPr>
            <a:xfrm>
              <a:off x="8147840" y="3581724"/>
              <a:ext cx="169515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5</a:t>
              </a:r>
            </a:p>
          </p:txBody>
        </p:sp>
        <p:sp>
          <p:nvSpPr>
            <p:cNvPr id="185" name="tx185"/>
            <p:cNvSpPr/>
            <p:nvPr/>
          </p:nvSpPr>
          <p:spPr>
            <a:xfrm>
              <a:off x="6950549" y="3757571"/>
              <a:ext cx="395101" cy="1293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ime</a:t>
              </a:r>
            </a:p>
          </p:txBody>
        </p:sp>
        <p:sp>
          <p:nvSpPr>
            <p:cNvPr id="186" name="tx186"/>
            <p:cNvSpPr/>
            <p:nvPr/>
          </p:nvSpPr>
          <p:spPr>
            <a:xfrm rot="-5400000">
              <a:off x="4767275" y="2795059"/>
              <a:ext cx="1403126" cy="16686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Beta(t) for </a:t>
              </a:r>
              <a:r>
                <a:rPr sz="1400" dirty="0" err="1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GTVnd</a:t>
              </a:r>
              <a:endParaRPr sz="1400" dirty="0">
                <a:solidFill>
                  <a:srgbClr val="000000">
                    <a:alpha val="100000"/>
                  </a:srgbClr>
                </a:solidFill>
                <a:latin typeface="Arial"/>
                <a:cs typeface="Arial"/>
              </a:endParaRPr>
            </a:p>
          </p:txBody>
        </p:sp>
        <p:sp>
          <p:nvSpPr>
            <p:cNvPr id="187" name="tx187"/>
            <p:cNvSpPr/>
            <p:nvPr/>
          </p:nvSpPr>
          <p:spPr>
            <a:xfrm>
              <a:off x="5422622" y="1960474"/>
              <a:ext cx="3287315" cy="18831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600" dirty="0" err="1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choenfeld</a:t>
              </a:r>
              <a:r>
                <a:rPr sz="16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 Individual Test p: 0.2651</a:t>
              </a:r>
            </a:p>
          </p:txBody>
        </p:sp>
        <p:sp>
          <p:nvSpPr>
            <p:cNvPr id="188" name="rc188"/>
            <p:cNvSpPr/>
            <p:nvPr/>
          </p:nvSpPr>
          <p:spPr>
            <a:xfrm>
              <a:off x="2148681" y="3991418"/>
              <a:ext cx="3200399" cy="207600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4782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9" name="rc189"/>
            <p:cNvSpPr/>
            <p:nvPr/>
          </p:nvSpPr>
          <p:spPr>
            <a:xfrm>
              <a:off x="2622234" y="4317278"/>
              <a:ext cx="2650932" cy="127443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90" name="pl190"/>
            <p:cNvSpPr/>
            <p:nvPr/>
          </p:nvSpPr>
          <p:spPr>
            <a:xfrm>
              <a:off x="2742731" y="4873139"/>
              <a:ext cx="2409938" cy="178204"/>
            </a:xfrm>
            <a:custGeom>
              <a:avLst/>
              <a:gdLst/>
              <a:ahLst/>
              <a:cxnLst/>
              <a:rect l="0" t="0" r="0" b="0"/>
              <a:pathLst>
                <a:path w="2409938" h="178204">
                  <a:moveTo>
                    <a:pt x="0" y="178204"/>
                  </a:moveTo>
                  <a:lnTo>
                    <a:pt x="61793" y="162360"/>
                  </a:lnTo>
                  <a:lnTo>
                    <a:pt x="123586" y="146864"/>
                  </a:lnTo>
                  <a:lnTo>
                    <a:pt x="185379" y="132065"/>
                  </a:lnTo>
                  <a:lnTo>
                    <a:pt x="247173" y="118310"/>
                  </a:lnTo>
                  <a:lnTo>
                    <a:pt x="308966" y="105949"/>
                  </a:lnTo>
                  <a:lnTo>
                    <a:pt x="370759" y="95329"/>
                  </a:lnTo>
                  <a:lnTo>
                    <a:pt x="432553" y="86798"/>
                  </a:lnTo>
                  <a:lnTo>
                    <a:pt x="494346" y="80705"/>
                  </a:lnTo>
                  <a:lnTo>
                    <a:pt x="556139" y="77276"/>
                  </a:lnTo>
                  <a:lnTo>
                    <a:pt x="617932" y="76261"/>
                  </a:lnTo>
                  <a:lnTo>
                    <a:pt x="679726" y="77296"/>
                  </a:lnTo>
                  <a:lnTo>
                    <a:pt x="741519" y="80016"/>
                  </a:lnTo>
                  <a:lnTo>
                    <a:pt x="803312" y="84058"/>
                  </a:lnTo>
                  <a:lnTo>
                    <a:pt x="865106" y="89056"/>
                  </a:lnTo>
                  <a:lnTo>
                    <a:pt x="926899" y="94648"/>
                  </a:lnTo>
                  <a:lnTo>
                    <a:pt x="988692" y="100468"/>
                  </a:lnTo>
                  <a:lnTo>
                    <a:pt x="1050485" y="106152"/>
                  </a:lnTo>
                  <a:lnTo>
                    <a:pt x="1112279" y="111336"/>
                  </a:lnTo>
                  <a:lnTo>
                    <a:pt x="1174072" y="115656"/>
                  </a:lnTo>
                  <a:lnTo>
                    <a:pt x="1235865" y="118758"/>
                  </a:lnTo>
                  <a:lnTo>
                    <a:pt x="1297659" y="120500"/>
                  </a:lnTo>
                  <a:lnTo>
                    <a:pt x="1359452" y="120945"/>
                  </a:lnTo>
                  <a:lnTo>
                    <a:pt x="1421245" y="120167"/>
                  </a:lnTo>
                  <a:lnTo>
                    <a:pt x="1483038" y="118237"/>
                  </a:lnTo>
                  <a:lnTo>
                    <a:pt x="1544832" y="115226"/>
                  </a:lnTo>
                  <a:lnTo>
                    <a:pt x="1606625" y="111208"/>
                  </a:lnTo>
                  <a:lnTo>
                    <a:pt x="1668418" y="106253"/>
                  </a:lnTo>
                  <a:lnTo>
                    <a:pt x="1730212" y="100435"/>
                  </a:lnTo>
                  <a:lnTo>
                    <a:pt x="1792005" y="93825"/>
                  </a:lnTo>
                  <a:lnTo>
                    <a:pt x="1853798" y="86494"/>
                  </a:lnTo>
                  <a:lnTo>
                    <a:pt x="1915591" y="78516"/>
                  </a:lnTo>
                  <a:lnTo>
                    <a:pt x="1977385" y="69961"/>
                  </a:lnTo>
                  <a:lnTo>
                    <a:pt x="2039178" y="60903"/>
                  </a:lnTo>
                  <a:lnTo>
                    <a:pt x="2100971" y="51412"/>
                  </a:lnTo>
                  <a:lnTo>
                    <a:pt x="2162765" y="41562"/>
                  </a:lnTo>
                  <a:lnTo>
                    <a:pt x="2224558" y="31423"/>
                  </a:lnTo>
                  <a:lnTo>
                    <a:pt x="2286351" y="21069"/>
                  </a:lnTo>
                  <a:lnTo>
                    <a:pt x="2348144" y="10570"/>
                  </a:lnTo>
                  <a:lnTo>
                    <a:pt x="2409938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1" name="pt191"/>
            <p:cNvSpPr/>
            <p:nvPr/>
          </p:nvSpPr>
          <p:spPr>
            <a:xfrm>
              <a:off x="2724680" y="474054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2" name="pt192"/>
            <p:cNvSpPr/>
            <p:nvPr/>
          </p:nvSpPr>
          <p:spPr>
            <a:xfrm>
              <a:off x="2742285" y="5438542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3" name="pt193"/>
            <p:cNvSpPr/>
            <p:nvPr/>
          </p:nvSpPr>
          <p:spPr>
            <a:xfrm>
              <a:off x="2760187" y="537281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4" name="pt194"/>
            <p:cNvSpPr/>
            <p:nvPr/>
          </p:nvSpPr>
          <p:spPr>
            <a:xfrm>
              <a:off x="2778336" y="5375350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5" name="pt195"/>
            <p:cNvSpPr/>
            <p:nvPr/>
          </p:nvSpPr>
          <p:spPr>
            <a:xfrm>
              <a:off x="2796674" y="4762892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6" name="pt196"/>
            <p:cNvSpPr/>
            <p:nvPr/>
          </p:nvSpPr>
          <p:spPr>
            <a:xfrm>
              <a:off x="2815206" y="551573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7" name="pt197"/>
            <p:cNvSpPr/>
            <p:nvPr/>
          </p:nvSpPr>
          <p:spPr>
            <a:xfrm>
              <a:off x="2834006" y="542164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8" name="pt198"/>
            <p:cNvSpPr/>
            <p:nvPr/>
          </p:nvSpPr>
          <p:spPr>
            <a:xfrm>
              <a:off x="2852805" y="4673546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9" name="pt199"/>
            <p:cNvSpPr/>
            <p:nvPr/>
          </p:nvSpPr>
          <p:spPr>
            <a:xfrm>
              <a:off x="2871880" y="4671022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0" name="pt200"/>
            <p:cNvSpPr/>
            <p:nvPr/>
          </p:nvSpPr>
          <p:spPr>
            <a:xfrm>
              <a:off x="2891027" y="544422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1" name="pt201"/>
            <p:cNvSpPr/>
            <p:nvPr/>
          </p:nvSpPr>
          <p:spPr>
            <a:xfrm>
              <a:off x="2910316" y="469759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2" name="pt202"/>
            <p:cNvSpPr/>
            <p:nvPr/>
          </p:nvSpPr>
          <p:spPr>
            <a:xfrm>
              <a:off x="2929679" y="4684438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3" name="pt203"/>
            <p:cNvSpPr/>
            <p:nvPr/>
          </p:nvSpPr>
          <p:spPr>
            <a:xfrm>
              <a:off x="2949883" y="4683296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4" name="pt204"/>
            <p:cNvSpPr/>
            <p:nvPr/>
          </p:nvSpPr>
          <p:spPr>
            <a:xfrm>
              <a:off x="2970413" y="460220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5" name="pt205"/>
            <p:cNvSpPr/>
            <p:nvPr/>
          </p:nvSpPr>
          <p:spPr>
            <a:xfrm>
              <a:off x="2991720" y="4741830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6" name="pt206"/>
            <p:cNvSpPr/>
            <p:nvPr/>
          </p:nvSpPr>
          <p:spPr>
            <a:xfrm>
              <a:off x="3013208" y="4628130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7" name="pt207"/>
            <p:cNvSpPr/>
            <p:nvPr/>
          </p:nvSpPr>
          <p:spPr>
            <a:xfrm>
              <a:off x="3034696" y="4714756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8" name="pt208"/>
            <p:cNvSpPr/>
            <p:nvPr/>
          </p:nvSpPr>
          <p:spPr>
            <a:xfrm>
              <a:off x="3056184" y="4659836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9" name="pt209"/>
            <p:cNvSpPr/>
            <p:nvPr/>
          </p:nvSpPr>
          <p:spPr>
            <a:xfrm>
              <a:off x="3078145" y="4716360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0" name="pt210"/>
            <p:cNvSpPr/>
            <p:nvPr/>
          </p:nvSpPr>
          <p:spPr>
            <a:xfrm>
              <a:off x="3100302" y="470368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1" name="pt211"/>
            <p:cNvSpPr/>
            <p:nvPr/>
          </p:nvSpPr>
          <p:spPr>
            <a:xfrm>
              <a:off x="3122864" y="540442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2" name="pt212"/>
            <p:cNvSpPr/>
            <p:nvPr/>
          </p:nvSpPr>
          <p:spPr>
            <a:xfrm>
              <a:off x="3145426" y="546710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3" name="pt213"/>
            <p:cNvSpPr/>
            <p:nvPr/>
          </p:nvSpPr>
          <p:spPr>
            <a:xfrm>
              <a:off x="3168520" y="471694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4" name="pt214"/>
            <p:cNvSpPr/>
            <p:nvPr/>
          </p:nvSpPr>
          <p:spPr>
            <a:xfrm>
              <a:off x="3168520" y="548164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5" name="pt215"/>
            <p:cNvSpPr/>
            <p:nvPr/>
          </p:nvSpPr>
          <p:spPr>
            <a:xfrm>
              <a:off x="3217007" y="5391776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6" name="pt216"/>
            <p:cNvSpPr/>
            <p:nvPr/>
          </p:nvSpPr>
          <p:spPr>
            <a:xfrm>
              <a:off x="3241621" y="474574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7" name="pt217"/>
            <p:cNvSpPr/>
            <p:nvPr/>
          </p:nvSpPr>
          <p:spPr>
            <a:xfrm>
              <a:off x="3266883" y="473169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8" name="pt218"/>
            <p:cNvSpPr/>
            <p:nvPr/>
          </p:nvSpPr>
          <p:spPr>
            <a:xfrm>
              <a:off x="3292145" y="473945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9" name="pt219"/>
            <p:cNvSpPr/>
            <p:nvPr/>
          </p:nvSpPr>
          <p:spPr>
            <a:xfrm>
              <a:off x="3317956" y="472629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0" name="pt220"/>
            <p:cNvSpPr/>
            <p:nvPr/>
          </p:nvSpPr>
          <p:spPr>
            <a:xfrm>
              <a:off x="3344344" y="459045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1" name="pt221"/>
            <p:cNvSpPr/>
            <p:nvPr/>
          </p:nvSpPr>
          <p:spPr>
            <a:xfrm>
              <a:off x="3371494" y="472163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2" name="pt222"/>
            <p:cNvSpPr/>
            <p:nvPr/>
          </p:nvSpPr>
          <p:spPr>
            <a:xfrm>
              <a:off x="3399126" y="541546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3" name="pt223"/>
            <p:cNvSpPr/>
            <p:nvPr/>
          </p:nvSpPr>
          <p:spPr>
            <a:xfrm>
              <a:off x="3428508" y="542686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4" name="pt224"/>
            <p:cNvSpPr/>
            <p:nvPr/>
          </p:nvSpPr>
          <p:spPr>
            <a:xfrm>
              <a:off x="3458268" y="474364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5" name="pt225"/>
            <p:cNvSpPr/>
            <p:nvPr/>
          </p:nvSpPr>
          <p:spPr>
            <a:xfrm>
              <a:off x="3489446" y="465968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6" name="pt226"/>
            <p:cNvSpPr/>
            <p:nvPr/>
          </p:nvSpPr>
          <p:spPr>
            <a:xfrm>
              <a:off x="3520839" y="543921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7" name="pt227"/>
            <p:cNvSpPr/>
            <p:nvPr/>
          </p:nvSpPr>
          <p:spPr>
            <a:xfrm>
              <a:off x="3552673" y="477720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8" name="pt228"/>
            <p:cNvSpPr/>
            <p:nvPr/>
          </p:nvSpPr>
          <p:spPr>
            <a:xfrm>
              <a:off x="3586679" y="5367286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9" name="pt229"/>
            <p:cNvSpPr/>
            <p:nvPr/>
          </p:nvSpPr>
          <p:spPr>
            <a:xfrm>
              <a:off x="3620684" y="475104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0" name="pt230"/>
            <p:cNvSpPr/>
            <p:nvPr/>
          </p:nvSpPr>
          <p:spPr>
            <a:xfrm>
              <a:off x="3655769" y="463901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1" name="pt231"/>
            <p:cNvSpPr/>
            <p:nvPr/>
          </p:nvSpPr>
          <p:spPr>
            <a:xfrm>
              <a:off x="3692935" y="463164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2" name="pt232"/>
            <p:cNvSpPr/>
            <p:nvPr/>
          </p:nvSpPr>
          <p:spPr>
            <a:xfrm>
              <a:off x="3734747" y="538326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3" name="pt233"/>
            <p:cNvSpPr/>
            <p:nvPr/>
          </p:nvSpPr>
          <p:spPr>
            <a:xfrm>
              <a:off x="3776559" y="537345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4" name="pt234"/>
            <p:cNvSpPr/>
            <p:nvPr/>
          </p:nvSpPr>
          <p:spPr>
            <a:xfrm>
              <a:off x="3820984" y="5478152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5" name="pt235"/>
            <p:cNvSpPr/>
            <p:nvPr/>
          </p:nvSpPr>
          <p:spPr>
            <a:xfrm>
              <a:off x="3865882" y="537939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6" name="pt236"/>
            <p:cNvSpPr/>
            <p:nvPr/>
          </p:nvSpPr>
          <p:spPr>
            <a:xfrm>
              <a:off x="3912798" y="457453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7" name="pt237"/>
            <p:cNvSpPr/>
            <p:nvPr/>
          </p:nvSpPr>
          <p:spPr>
            <a:xfrm>
              <a:off x="3962540" y="537712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8" name="pt238"/>
            <p:cNvSpPr/>
            <p:nvPr/>
          </p:nvSpPr>
          <p:spPr>
            <a:xfrm>
              <a:off x="4017659" y="464163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9" name="pt239"/>
            <p:cNvSpPr/>
            <p:nvPr/>
          </p:nvSpPr>
          <p:spPr>
            <a:xfrm>
              <a:off x="4081528" y="4584712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0" name="pt240"/>
            <p:cNvSpPr/>
            <p:nvPr/>
          </p:nvSpPr>
          <p:spPr>
            <a:xfrm>
              <a:off x="4145397" y="457989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1" name="pt241"/>
            <p:cNvSpPr/>
            <p:nvPr/>
          </p:nvSpPr>
          <p:spPr>
            <a:xfrm>
              <a:off x="4216233" y="5384106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2" name="pt242"/>
            <p:cNvSpPr/>
            <p:nvPr/>
          </p:nvSpPr>
          <p:spPr>
            <a:xfrm>
              <a:off x="4288405" y="539977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3" name="pt243"/>
            <p:cNvSpPr/>
            <p:nvPr/>
          </p:nvSpPr>
          <p:spPr>
            <a:xfrm>
              <a:off x="4363465" y="4574570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4" name="pt244"/>
            <p:cNvSpPr/>
            <p:nvPr/>
          </p:nvSpPr>
          <p:spPr>
            <a:xfrm>
              <a:off x="4440088" y="463282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5" name="pt245"/>
            <p:cNvSpPr/>
            <p:nvPr/>
          </p:nvSpPr>
          <p:spPr>
            <a:xfrm>
              <a:off x="4523839" y="459423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6" name="pt246"/>
            <p:cNvSpPr/>
            <p:nvPr/>
          </p:nvSpPr>
          <p:spPr>
            <a:xfrm>
              <a:off x="4645134" y="516550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7" name="pt247"/>
            <p:cNvSpPr/>
            <p:nvPr/>
          </p:nvSpPr>
          <p:spPr>
            <a:xfrm>
              <a:off x="4766428" y="438898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8" name="pt248"/>
            <p:cNvSpPr/>
            <p:nvPr/>
          </p:nvSpPr>
          <p:spPr>
            <a:xfrm>
              <a:off x="4892388" y="517090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9" name="pt249"/>
            <p:cNvSpPr/>
            <p:nvPr/>
          </p:nvSpPr>
          <p:spPr>
            <a:xfrm>
              <a:off x="5134618" y="514843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50" name="pl250"/>
            <p:cNvSpPr/>
            <p:nvPr/>
          </p:nvSpPr>
          <p:spPr>
            <a:xfrm>
              <a:off x="2742731" y="4375207"/>
              <a:ext cx="2409938" cy="484034"/>
            </a:xfrm>
            <a:custGeom>
              <a:avLst/>
              <a:gdLst/>
              <a:ahLst/>
              <a:cxnLst/>
              <a:rect l="0" t="0" r="0" b="0"/>
              <a:pathLst>
                <a:path w="2409938" h="484034">
                  <a:moveTo>
                    <a:pt x="0" y="418921"/>
                  </a:moveTo>
                  <a:lnTo>
                    <a:pt x="61793" y="446592"/>
                  </a:lnTo>
                  <a:lnTo>
                    <a:pt x="123586" y="468782"/>
                  </a:lnTo>
                  <a:lnTo>
                    <a:pt x="185379" y="482279"/>
                  </a:lnTo>
                  <a:lnTo>
                    <a:pt x="247173" y="484034"/>
                  </a:lnTo>
                  <a:lnTo>
                    <a:pt x="308966" y="473898"/>
                  </a:lnTo>
                  <a:lnTo>
                    <a:pt x="370759" y="456279"/>
                  </a:lnTo>
                  <a:lnTo>
                    <a:pt x="432553" y="437518"/>
                  </a:lnTo>
                  <a:lnTo>
                    <a:pt x="494346" y="422861"/>
                  </a:lnTo>
                  <a:lnTo>
                    <a:pt x="556139" y="415331"/>
                  </a:lnTo>
                  <a:lnTo>
                    <a:pt x="617932" y="414771"/>
                  </a:lnTo>
                  <a:lnTo>
                    <a:pt x="679726" y="419662"/>
                  </a:lnTo>
                  <a:lnTo>
                    <a:pt x="741519" y="427908"/>
                  </a:lnTo>
                  <a:lnTo>
                    <a:pt x="803312" y="437074"/>
                  </a:lnTo>
                  <a:lnTo>
                    <a:pt x="865106" y="444714"/>
                  </a:lnTo>
                  <a:lnTo>
                    <a:pt x="926899" y="448919"/>
                  </a:lnTo>
                  <a:lnTo>
                    <a:pt x="988692" y="448885"/>
                  </a:lnTo>
                  <a:lnTo>
                    <a:pt x="1050485" y="445053"/>
                  </a:lnTo>
                  <a:lnTo>
                    <a:pt x="1112279" y="438713"/>
                  </a:lnTo>
                  <a:lnTo>
                    <a:pt x="1174072" y="431445"/>
                  </a:lnTo>
                  <a:lnTo>
                    <a:pt x="1235865" y="424729"/>
                  </a:lnTo>
                  <a:lnTo>
                    <a:pt x="1297659" y="419446"/>
                  </a:lnTo>
                  <a:lnTo>
                    <a:pt x="1359452" y="415761"/>
                  </a:lnTo>
                  <a:lnTo>
                    <a:pt x="1421245" y="413478"/>
                  </a:lnTo>
                  <a:lnTo>
                    <a:pt x="1483038" y="412131"/>
                  </a:lnTo>
                  <a:lnTo>
                    <a:pt x="1544832" y="411009"/>
                  </a:lnTo>
                  <a:lnTo>
                    <a:pt x="1606625" y="409163"/>
                  </a:lnTo>
                  <a:lnTo>
                    <a:pt x="1668418" y="405428"/>
                  </a:lnTo>
                  <a:lnTo>
                    <a:pt x="1730212" y="398500"/>
                  </a:lnTo>
                  <a:lnTo>
                    <a:pt x="1792005" y="387105"/>
                  </a:lnTo>
                  <a:lnTo>
                    <a:pt x="1853798" y="370232"/>
                  </a:lnTo>
                  <a:lnTo>
                    <a:pt x="1915591" y="347344"/>
                  </a:lnTo>
                  <a:lnTo>
                    <a:pt x="1977385" y="318438"/>
                  </a:lnTo>
                  <a:lnTo>
                    <a:pt x="2039178" y="283944"/>
                  </a:lnTo>
                  <a:lnTo>
                    <a:pt x="2100971" y="244545"/>
                  </a:lnTo>
                  <a:lnTo>
                    <a:pt x="2162765" y="201012"/>
                  </a:lnTo>
                  <a:lnTo>
                    <a:pt x="2224558" y="154109"/>
                  </a:lnTo>
                  <a:lnTo>
                    <a:pt x="2286351" y="104550"/>
                  </a:lnTo>
                  <a:lnTo>
                    <a:pt x="2348144" y="52984"/>
                  </a:lnTo>
                  <a:lnTo>
                    <a:pt x="2409938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51" name="pl251"/>
            <p:cNvSpPr/>
            <p:nvPr/>
          </p:nvSpPr>
          <p:spPr>
            <a:xfrm>
              <a:off x="2742731" y="5102113"/>
              <a:ext cx="2409938" cy="268958"/>
            </a:xfrm>
            <a:custGeom>
              <a:avLst/>
              <a:gdLst/>
              <a:ahLst/>
              <a:cxnLst/>
              <a:rect l="0" t="0" r="0" b="0"/>
              <a:pathLst>
                <a:path w="2409938" h="268958">
                  <a:moveTo>
                    <a:pt x="0" y="206446"/>
                  </a:moveTo>
                  <a:lnTo>
                    <a:pt x="61793" y="147087"/>
                  </a:lnTo>
                  <a:lnTo>
                    <a:pt x="123586" y="93905"/>
                  </a:lnTo>
                  <a:lnTo>
                    <a:pt x="185379" y="50810"/>
                  </a:lnTo>
                  <a:lnTo>
                    <a:pt x="247173" y="21546"/>
                  </a:lnTo>
                  <a:lnTo>
                    <a:pt x="308966" y="6958"/>
                  </a:lnTo>
                  <a:lnTo>
                    <a:pt x="370759" y="3337"/>
                  </a:lnTo>
                  <a:lnTo>
                    <a:pt x="432553" y="5037"/>
                  </a:lnTo>
                  <a:lnTo>
                    <a:pt x="494346" y="7508"/>
                  </a:lnTo>
                  <a:lnTo>
                    <a:pt x="556139" y="8180"/>
                  </a:lnTo>
                  <a:lnTo>
                    <a:pt x="617932" y="6709"/>
                  </a:lnTo>
                  <a:lnTo>
                    <a:pt x="679726" y="3888"/>
                  </a:lnTo>
                  <a:lnTo>
                    <a:pt x="741519" y="1082"/>
                  </a:lnTo>
                  <a:lnTo>
                    <a:pt x="803312" y="0"/>
                  </a:lnTo>
                  <a:lnTo>
                    <a:pt x="865106" y="2357"/>
                  </a:lnTo>
                  <a:lnTo>
                    <a:pt x="926899" y="9335"/>
                  </a:lnTo>
                  <a:lnTo>
                    <a:pt x="988692" y="21009"/>
                  </a:lnTo>
                  <a:lnTo>
                    <a:pt x="1050485" y="36210"/>
                  </a:lnTo>
                  <a:lnTo>
                    <a:pt x="1112279" y="52918"/>
                  </a:lnTo>
                  <a:lnTo>
                    <a:pt x="1174072" y="68826"/>
                  </a:lnTo>
                  <a:lnTo>
                    <a:pt x="1235865" y="81746"/>
                  </a:lnTo>
                  <a:lnTo>
                    <a:pt x="1297659" y="90512"/>
                  </a:lnTo>
                  <a:lnTo>
                    <a:pt x="1359452" y="95088"/>
                  </a:lnTo>
                  <a:lnTo>
                    <a:pt x="1421245" y="95814"/>
                  </a:lnTo>
                  <a:lnTo>
                    <a:pt x="1483038" y="93300"/>
                  </a:lnTo>
                  <a:lnTo>
                    <a:pt x="1544832" y="88402"/>
                  </a:lnTo>
                  <a:lnTo>
                    <a:pt x="1606625" y="82211"/>
                  </a:lnTo>
                  <a:lnTo>
                    <a:pt x="1668418" y="76037"/>
                  </a:lnTo>
                  <a:lnTo>
                    <a:pt x="1730212" y="71328"/>
                  </a:lnTo>
                  <a:lnTo>
                    <a:pt x="1792005" y="69503"/>
                  </a:lnTo>
                  <a:lnTo>
                    <a:pt x="1853798" y="71715"/>
                  </a:lnTo>
                  <a:lnTo>
                    <a:pt x="1915591" y="78646"/>
                  </a:lnTo>
                  <a:lnTo>
                    <a:pt x="1977385" y="90443"/>
                  </a:lnTo>
                  <a:lnTo>
                    <a:pt x="2039178" y="106820"/>
                  </a:lnTo>
                  <a:lnTo>
                    <a:pt x="2100971" y="127238"/>
                  </a:lnTo>
                  <a:lnTo>
                    <a:pt x="2162765" y="151070"/>
                  </a:lnTo>
                  <a:lnTo>
                    <a:pt x="2224558" y="177695"/>
                  </a:lnTo>
                  <a:lnTo>
                    <a:pt x="2286351" y="206545"/>
                  </a:lnTo>
                  <a:lnTo>
                    <a:pt x="2348144" y="237115"/>
                  </a:lnTo>
                  <a:lnTo>
                    <a:pt x="2409938" y="268958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52" name="pl252"/>
            <p:cNvSpPr/>
            <p:nvPr/>
          </p:nvSpPr>
          <p:spPr>
            <a:xfrm>
              <a:off x="2622234" y="4317278"/>
              <a:ext cx="0" cy="1274435"/>
            </a:xfrm>
            <a:custGeom>
              <a:avLst/>
              <a:gdLst/>
              <a:ahLst/>
              <a:cxnLst/>
              <a:rect l="0" t="0" r="0" b="0"/>
              <a:pathLst>
                <a:path h="1274435">
                  <a:moveTo>
                    <a:pt x="0" y="1274435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53" name="tx253"/>
            <p:cNvSpPr/>
            <p:nvPr/>
          </p:nvSpPr>
          <p:spPr>
            <a:xfrm>
              <a:off x="2418402" y="5357833"/>
              <a:ext cx="135508" cy="10953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2</a:t>
              </a:r>
            </a:p>
          </p:txBody>
        </p:sp>
        <p:sp>
          <p:nvSpPr>
            <p:cNvPr id="254" name="tx254"/>
            <p:cNvSpPr/>
            <p:nvPr/>
          </p:nvSpPr>
          <p:spPr>
            <a:xfrm>
              <a:off x="2469152" y="5010238"/>
              <a:ext cx="84757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255" name="tx255"/>
            <p:cNvSpPr/>
            <p:nvPr/>
          </p:nvSpPr>
          <p:spPr>
            <a:xfrm>
              <a:off x="2469152" y="4666364"/>
              <a:ext cx="84757" cy="10953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256" name="tx256"/>
            <p:cNvSpPr/>
            <p:nvPr/>
          </p:nvSpPr>
          <p:spPr>
            <a:xfrm>
              <a:off x="2469152" y="4321076"/>
              <a:ext cx="84757" cy="10909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257" name="pl257"/>
            <p:cNvSpPr/>
            <p:nvPr/>
          </p:nvSpPr>
          <p:spPr>
            <a:xfrm>
              <a:off x="2584276" y="5412825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58" name="pl258"/>
            <p:cNvSpPr/>
            <p:nvPr/>
          </p:nvSpPr>
          <p:spPr>
            <a:xfrm>
              <a:off x="2584276" y="5067090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59" name="pl259"/>
            <p:cNvSpPr/>
            <p:nvPr/>
          </p:nvSpPr>
          <p:spPr>
            <a:xfrm>
              <a:off x="2584276" y="4721356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0" name="pl260"/>
            <p:cNvSpPr/>
            <p:nvPr/>
          </p:nvSpPr>
          <p:spPr>
            <a:xfrm>
              <a:off x="2584276" y="4375621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1" name="pl261"/>
            <p:cNvSpPr/>
            <p:nvPr/>
          </p:nvSpPr>
          <p:spPr>
            <a:xfrm>
              <a:off x="2622234" y="5591714"/>
              <a:ext cx="2650932" cy="0"/>
            </a:xfrm>
            <a:custGeom>
              <a:avLst/>
              <a:gdLst/>
              <a:ahLst/>
              <a:cxnLst/>
              <a:rect l="0" t="0" r="0" b="0"/>
              <a:pathLst>
                <a:path w="2650932">
                  <a:moveTo>
                    <a:pt x="0" y="0"/>
                  </a:moveTo>
                  <a:lnTo>
                    <a:pt x="2650932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2" name="pl262"/>
            <p:cNvSpPr/>
            <p:nvPr/>
          </p:nvSpPr>
          <p:spPr>
            <a:xfrm>
              <a:off x="2891543" y="5591714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3" name="pl263"/>
            <p:cNvSpPr/>
            <p:nvPr/>
          </p:nvSpPr>
          <p:spPr>
            <a:xfrm>
              <a:off x="3185793" y="5591714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4" name="pl264"/>
            <p:cNvSpPr/>
            <p:nvPr/>
          </p:nvSpPr>
          <p:spPr>
            <a:xfrm>
              <a:off x="3501753" y="5591714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5" name="pl265"/>
            <p:cNvSpPr/>
            <p:nvPr/>
          </p:nvSpPr>
          <p:spPr>
            <a:xfrm>
              <a:off x="3789281" y="5591714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6" name="pl266"/>
            <p:cNvSpPr/>
            <p:nvPr/>
          </p:nvSpPr>
          <p:spPr>
            <a:xfrm>
              <a:off x="4099861" y="5591714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7" name="pl267"/>
            <p:cNvSpPr/>
            <p:nvPr/>
          </p:nvSpPr>
          <p:spPr>
            <a:xfrm>
              <a:off x="4402970" y="5591714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8" name="pl268"/>
            <p:cNvSpPr/>
            <p:nvPr/>
          </p:nvSpPr>
          <p:spPr>
            <a:xfrm>
              <a:off x="4536278" y="5591714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9" name="pl269"/>
            <p:cNvSpPr/>
            <p:nvPr/>
          </p:nvSpPr>
          <p:spPr>
            <a:xfrm>
              <a:off x="5032198" y="5591714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0" name="tx270"/>
            <p:cNvSpPr/>
            <p:nvPr/>
          </p:nvSpPr>
          <p:spPr>
            <a:xfrm>
              <a:off x="2743236" y="5657731"/>
              <a:ext cx="296614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26</a:t>
              </a:r>
            </a:p>
          </p:txBody>
        </p:sp>
        <p:sp>
          <p:nvSpPr>
            <p:cNvPr id="271" name="tx271"/>
            <p:cNvSpPr/>
            <p:nvPr/>
          </p:nvSpPr>
          <p:spPr>
            <a:xfrm>
              <a:off x="3143414" y="5659591"/>
              <a:ext cx="84757" cy="10953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272" name="tx272"/>
            <p:cNvSpPr/>
            <p:nvPr/>
          </p:nvSpPr>
          <p:spPr>
            <a:xfrm>
              <a:off x="3395825" y="5659591"/>
              <a:ext cx="211856" cy="10953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.7</a:t>
              </a:r>
            </a:p>
          </p:txBody>
        </p:sp>
        <p:sp>
          <p:nvSpPr>
            <p:cNvPr id="273" name="tx273"/>
            <p:cNvSpPr/>
            <p:nvPr/>
          </p:nvSpPr>
          <p:spPr>
            <a:xfrm>
              <a:off x="3683352" y="5657656"/>
              <a:ext cx="211856" cy="11147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.3</a:t>
              </a:r>
            </a:p>
          </p:txBody>
        </p:sp>
        <p:sp>
          <p:nvSpPr>
            <p:cNvPr id="274" name="tx274"/>
            <p:cNvSpPr/>
            <p:nvPr/>
          </p:nvSpPr>
          <p:spPr>
            <a:xfrm>
              <a:off x="3993933" y="5657731"/>
              <a:ext cx="211856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.4</a:t>
              </a:r>
            </a:p>
          </p:txBody>
        </p:sp>
        <p:sp>
          <p:nvSpPr>
            <p:cNvPr id="275" name="tx275"/>
            <p:cNvSpPr/>
            <p:nvPr/>
          </p:nvSpPr>
          <p:spPr>
            <a:xfrm>
              <a:off x="4297042" y="5657731"/>
              <a:ext cx="211856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.8</a:t>
              </a:r>
            </a:p>
          </p:txBody>
        </p:sp>
        <p:sp>
          <p:nvSpPr>
            <p:cNvPr id="276" name="tx276"/>
            <p:cNvSpPr/>
            <p:nvPr/>
          </p:nvSpPr>
          <p:spPr>
            <a:xfrm>
              <a:off x="4451520" y="5657731"/>
              <a:ext cx="169515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277" name="tx277"/>
            <p:cNvSpPr/>
            <p:nvPr/>
          </p:nvSpPr>
          <p:spPr>
            <a:xfrm>
              <a:off x="4947440" y="5657731"/>
              <a:ext cx="169515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5</a:t>
              </a:r>
            </a:p>
          </p:txBody>
        </p:sp>
        <p:sp>
          <p:nvSpPr>
            <p:cNvPr id="278" name="tx278"/>
            <p:cNvSpPr/>
            <p:nvPr/>
          </p:nvSpPr>
          <p:spPr>
            <a:xfrm>
              <a:off x="3750149" y="5833578"/>
              <a:ext cx="395101" cy="1293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ime</a:t>
              </a:r>
            </a:p>
          </p:txBody>
        </p:sp>
        <p:sp>
          <p:nvSpPr>
            <p:cNvPr id="279" name="tx279"/>
            <p:cNvSpPr/>
            <p:nvPr/>
          </p:nvSpPr>
          <p:spPr>
            <a:xfrm rot="-5400000">
              <a:off x="1443292" y="4871066"/>
              <a:ext cx="1650293" cy="16686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Beta(t) for Neutrophil</a:t>
              </a:r>
            </a:p>
          </p:txBody>
        </p:sp>
        <p:sp>
          <p:nvSpPr>
            <p:cNvPr id="280" name="tx280"/>
            <p:cNvSpPr/>
            <p:nvPr/>
          </p:nvSpPr>
          <p:spPr>
            <a:xfrm>
              <a:off x="2222223" y="4025055"/>
              <a:ext cx="3287315" cy="18831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600" dirty="0" err="1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choenfeld</a:t>
              </a:r>
              <a:r>
                <a:rPr sz="16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 Individual Test p: 0.6946</a:t>
              </a:r>
            </a:p>
          </p:txBody>
        </p:sp>
        <p:sp>
          <p:nvSpPr>
            <p:cNvPr id="281" name="rc281"/>
            <p:cNvSpPr/>
            <p:nvPr/>
          </p:nvSpPr>
          <p:spPr>
            <a:xfrm>
              <a:off x="5349081" y="3991418"/>
              <a:ext cx="3200399" cy="207600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4782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2" name="rc282"/>
            <p:cNvSpPr/>
            <p:nvPr/>
          </p:nvSpPr>
          <p:spPr>
            <a:xfrm>
              <a:off x="5822634" y="4317278"/>
              <a:ext cx="2650932" cy="127443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83" name="pl283"/>
            <p:cNvSpPr/>
            <p:nvPr/>
          </p:nvSpPr>
          <p:spPr>
            <a:xfrm>
              <a:off x="5943131" y="4685838"/>
              <a:ext cx="2409938" cy="197487"/>
            </a:xfrm>
            <a:custGeom>
              <a:avLst/>
              <a:gdLst/>
              <a:ahLst/>
              <a:cxnLst/>
              <a:rect l="0" t="0" r="0" b="0"/>
              <a:pathLst>
                <a:path w="2409938" h="197487">
                  <a:moveTo>
                    <a:pt x="0" y="197487"/>
                  </a:moveTo>
                  <a:lnTo>
                    <a:pt x="61793" y="175628"/>
                  </a:lnTo>
                  <a:lnTo>
                    <a:pt x="123586" y="154047"/>
                  </a:lnTo>
                  <a:lnTo>
                    <a:pt x="185379" y="133025"/>
                  </a:lnTo>
                  <a:lnTo>
                    <a:pt x="247173" y="112838"/>
                  </a:lnTo>
                  <a:lnTo>
                    <a:pt x="308966" y="93767"/>
                  </a:lnTo>
                  <a:lnTo>
                    <a:pt x="370759" y="76091"/>
                  </a:lnTo>
                  <a:lnTo>
                    <a:pt x="432553" y="60087"/>
                  </a:lnTo>
                  <a:lnTo>
                    <a:pt x="494346" y="46036"/>
                  </a:lnTo>
                  <a:lnTo>
                    <a:pt x="556139" y="34140"/>
                  </a:lnTo>
                  <a:lnTo>
                    <a:pt x="617932" y="24313"/>
                  </a:lnTo>
                  <a:lnTo>
                    <a:pt x="679726" y="16398"/>
                  </a:lnTo>
                  <a:lnTo>
                    <a:pt x="741519" y="10238"/>
                  </a:lnTo>
                  <a:lnTo>
                    <a:pt x="803312" y="5675"/>
                  </a:lnTo>
                  <a:lnTo>
                    <a:pt x="865106" y="2552"/>
                  </a:lnTo>
                  <a:lnTo>
                    <a:pt x="926899" y="713"/>
                  </a:lnTo>
                  <a:lnTo>
                    <a:pt x="988692" y="0"/>
                  </a:lnTo>
                  <a:lnTo>
                    <a:pt x="1050485" y="255"/>
                  </a:lnTo>
                  <a:lnTo>
                    <a:pt x="1112279" y="1322"/>
                  </a:lnTo>
                  <a:lnTo>
                    <a:pt x="1174072" y="3044"/>
                  </a:lnTo>
                  <a:lnTo>
                    <a:pt x="1235865" y="5266"/>
                  </a:lnTo>
                  <a:lnTo>
                    <a:pt x="1297659" y="7901"/>
                  </a:lnTo>
                  <a:lnTo>
                    <a:pt x="1359452" y="10924"/>
                  </a:lnTo>
                  <a:lnTo>
                    <a:pt x="1421245" y="14315"/>
                  </a:lnTo>
                  <a:lnTo>
                    <a:pt x="1483038" y="18050"/>
                  </a:lnTo>
                  <a:lnTo>
                    <a:pt x="1544832" y="22110"/>
                  </a:lnTo>
                  <a:lnTo>
                    <a:pt x="1606625" y="26472"/>
                  </a:lnTo>
                  <a:lnTo>
                    <a:pt x="1668418" y="31114"/>
                  </a:lnTo>
                  <a:lnTo>
                    <a:pt x="1730212" y="36015"/>
                  </a:lnTo>
                  <a:lnTo>
                    <a:pt x="1792005" y="41154"/>
                  </a:lnTo>
                  <a:lnTo>
                    <a:pt x="1853798" y="46508"/>
                  </a:lnTo>
                  <a:lnTo>
                    <a:pt x="1915591" y="52057"/>
                  </a:lnTo>
                  <a:lnTo>
                    <a:pt x="1977385" y="57778"/>
                  </a:lnTo>
                  <a:lnTo>
                    <a:pt x="2039178" y="63651"/>
                  </a:lnTo>
                  <a:lnTo>
                    <a:pt x="2100971" y="69653"/>
                  </a:lnTo>
                  <a:lnTo>
                    <a:pt x="2162765" y="75763"/>
                  </a:lnTo>
                  <a:lnTo>
                    <a:pt x="2224558" y="81959"/>
                  </a:lnTo>
                  <a:lnTo>
                    <a:pt x="2286351" y="88220"/>
                  </a:lnTo>
                  <a:lnTo>
                    <a:pt x="2348144" y="94524"/>
                  </a:lnTo>
                  <a:lnTo>
                    <a:pt x="2409938" y="10085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4" name="pt284"/>
            <p:cNvSpPr/>
            <p:nvPr/>
          </p:nvSpPr>
          <p:spPr>
            <a:xfrm>
              <a:off x="5925080" y="458080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5" name="pt285"/>
            <p:cNvSpPr/>
            <p:nvPr/>
          </p:nvSpPr>
          <p:spPr>
            <a:xfrm>
              <a:off x="5942685" y="465095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6" name="pt286"/>
            <p:cNvSpPr/>
            <p:nvPr/>
          </p:nvSpPr>
          <p:spPr>
            <a:xfrm>
              <a:off x="5960587" y="5382222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7" name="pt287"/>
            <p:cNvSpPr/>
            <p:nvPr/>
          </p:nvSpPr>
          <p:spPr>
            <a:xfrm>
              <a:off x="5978736" y="5383042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8" name="pt288"/>
            <p:cNvSpPr/>
            <p:nvPr/>
          </p:nvSpPr>
          <p:spPr>
            <a:xfrm>
              <a:off x="5997074" y="465930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9" name="pt289"/>
            <p:cNvSpPr/>
            <p:nvPr/>
          </p:nvSpPr>
          <p:spPr>
            <a:xfrm>
              <a:off x="6015606" y="462766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0" name="pt290"/>
            <p:cNvSpPr/>
            <p:nvPr/>
          </p:nvSpPr>
          <p:spPr>
            <a:xfrm>
              <a:off x="6034406" y="457051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1" name="pt291"/>
            <p:cNvSpPr/>
            <p:nvPr/>
          </p:nvSpPr>
          <p:spPr>
            <a:xfrm>
              <a:off x="6053205" y="4600226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2" name="pt292"/>
            <p:cNvSpPr/>
            <p:nvPr/>
          </p:nvSpPr>
          <p:spPr>
            <a:xfrm>
              <a:off x="6072280" y="459889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3" name="pt293"/>
            <p:cNvSpPr/>
            <p:nvPr/>
          </p:nvSpPr>
          <p:spPr>
            <a:xfrm>
              <a:off x="6091427" y="464724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4" name="pt294"/>
            <p:cNvSpPr/>
            <p:nvPr/>
          </p:nvSpPr>
          <p:spPr>
            <a:xfrm>
              <a:off x="6110716" y="467662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5" name="pt295"/>
            <p:cNvSpPr/>
            <p:nvPr/>
          </p:nvSpPr>
          <p:spPr>
            <a:xfrm>
              <a:off x="6130079" y="538227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6" name="pt296"/>
            <p:cNvSpPr/>
            <p:nvPr/>
          </p:nvSpPr>
          <p:spPr>
            <a:xfrm>
              <a:off x="6150283" y="467128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7" name="pt297"/>
            <p:cNvSpPr/>
            <p:nvPr/>
          </p:nvSpPr>
          <p:spPr>
            <a:xfrm>
              <a:off x="6170813" y="5400160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8" name="pt298"/>
            <p:cNvSpPr/>
            <p:nvPr/>
          </p:nvSpPr>
          <p:spPr>
            <a:xfrm>
              <a:off x="6192120" y="464600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9" name="pt299"/>
            <p:cNvSpPr/>
            <p:nvPr/>
          </p:nvSpPr>
          <p:spPr>
            <a:xfrm>
              <a:off x="6213608" y="551573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0" name="pt300"/>
            <p:cNvSpPr/>
            <p:nvPr/>
          </p:nvSpPr>
          <p:spPr>
            <a:xfrm>
              <a:off x="6235096" y="4572276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1" name="pt301"/>
            <p:cNvSpPr/>
            <p:nvPr/>
          </p:nvSpPr>
          <p:spPr>
            <a:xfrm>
              <a:off x="6256584" y="4678810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2" name="pt302"/>
            <p:cNvSpPr/>
            <p:nvPr/>
          </p:nvSpPr>
          <p:spPr>
            <a:xfrm>
              <a:off x="6278545" y="461813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3" name="pt303"/>
            <p:cNvSpPr/>
            <p:nvPr/>
          </p:nvSpPr>
          <p:spPr>
            <a:xfrm>
              <a:off x="6300702" y="457760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4" name="pt304"/>
            <p:cNvSpPr/>
            <p:nvPr/>
          </p:nvSpPr>
          <p:spPr>
            <a:xfrm>
              <a:off x="6323264" y="464597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5" name="pt305"/>
            <p:cNvSpPr/>
            <p:nvPr/>
          </p:nvSpPr>
          <p:spPr>
            <a:xfrm>
              <a:off x="6345826" y="458350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6" name="pt306"/>
            <p:cNvSpPr/>
            <p:nvPr/>
          </p:nvSpPr>
          <p:spPr>
            <a:xfrm>
              <a:off x="6368920" y="457636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7" name="pt307"/>
            <p:cNvSpPr/>
            <p:nvPr/>
          </p:nvSpPr>
          <p:spPr>
            <a:xfrm>
              <a:off x="6368920" y="4584618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8" name="pt308"/>
            <p:cNvSpPr/>
            <p:nvPr/>
          </p:nvSpPr>
          <p:spPr>
            <a:xfrm>
              <a:off x="6417407" y="456334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9" name="pt309"/>
            <p:cNvSpPr/>
            <p:nvPr/>
          </p:nvSpPr>
          <p:spPr>
            <a:xfrm>
              <a:off x="6442021" y="4648646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0" name="pt310"/>
            <p:cNvSpPr/>
            <p:nvPr/>
          </p:nvSpPr>
          <p:spPr>
            <a:xfrm>
              <a:off x="6467283" y="4608446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1" name="pt311"/>
            <p:cNvSpPr/>
            <p:nvPr/>
          </p:nvSpPr>
          <p:spPr>
            <a:xfrm>
              <a:off x="6492545" y="464651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2" name="pt312"/>
            <p:cNvSpPr/>
            <p:nvPr/>
          </p:nvSpPr>
          <p:spPr>
            <a:xfrm>
              <a:off x="6518356" y="4640330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3" name="pt313"/>
            <p:cNvSpPr/>
            <p:nvPr/>
          </p:nvSpPr>
          <p:spPr>
            <a:xfrm>
              <a:off x="6544744" y="543054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4" name="pt314"/>
            <p:cNvSpPr/>
            <p:nvPr/>
          </p:nvSpPr>
          <p:spPr>
            <a:xfrm>
              <a:off x="6571894" y="463627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5" name="pt315"/>
            <p:cNvSpPr/>
            <p:nvPr/>
          </p:nvSpPr>
          <p:spPr>
            <a:xfrm>
              <a:off x="6599526" y="467135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6" name="pt316"/>
            <p:cNvSpPr/>
            <p:nvPr/>
          </p:nvSpPr>
          <p:spPr>
            <a:xfrm>
              <a:off x="6628908" y="462759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7" name="pt317"/>
            <p:cNvSpPr/>
            <p:nvPr/>
          </p:nvSpPr>
          <p:spPr>
            <a:xfrm>
              <a:off x="6658668" y="4594246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8" name="pt318"/>
            <p:cNvSpPr/>
            <p:nvPr/>
          </p:nvSpPr>
          <p:spPr>
            <a:xfrm>
              <a:off x="6689846" y="457339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9" name="pt319"/>
            <p:cNvSpPr/>
            <p:nvPr/>
          </p:nvSpPr>
          <p:spPr>
            <a:xfrm>
              <a:off x="6721239" y="4617702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0" name="pt320"/>
            <p:cNvSpPr/>
            <p:nvPr/>
          </p:nvSpPr>
          <p:spPr>
            <a:xfrm>
              <a:off x="6753073" y="466255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1" name="pt321"/>
            <p:cNvSpPr/>
            <p:nvPr/>
          </p:nvSpPr>
          <p:spPr>
            <a:xfrm>
              <a:off x="6787079" y="534321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2" name="pt322"/>
            <p:cNvSpPr/>
            <p:nvPr/>
          </p:nvSpPr>
          <p:spPr>
            <a:xfrm>
              <a:off x="6821084" y="461883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3" name="pt323"/>
            <p:cNvSpPr/>
            <p:nvPr/>
          </p:nvSpPr>
          <p:spPr>
            <a:xfrm>
              <a:off x="6856169" y="455294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4" name="pt324"/>
            <p:cNvSpPr/>
            <p:nvPr/>
          </p:nvSpPr>
          <p:spPr>
            <a:xfrm>
              <a:off x="6893335" y="458479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5" name="pt325"/>
            <p:cNvSpPr/>
            <p:nvPr/>
          </p:nvSpPr>
          <p:spPr>
            <a:xfrm>
              <a:off x="6935147" y="458721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6" name="pt326"/>
            <p:cNvSpPr/>
            <p:nvPr/>
          </p:nvSpPr>
          <p:spPr>
            <a:xfrm>
              <a:off x="6976959" y="451495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7" name="pt327"/>
            <p:cNvSpPr/>
            <p:nvPr/>
          </p:nvSpPr>
          <p:spPr>
            <a:xfrm>
              <a:off x="7021384" y="457006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8" name="pt328"/>
            <p:cNvSpPr/>
            <p:nvPr/>
          </p:nvSpPr>
          <p:spPr>
            <a:xfrm>
              <a:off x="7066282" y="4504216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9" name="pt329"/>
            <p:cNvSpPr/>
            <p:nvPr/>
          </p:nvSpPr>
          <p:spPr>
            <a:xfrm>
              <a:off x="7113198" y="5340485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0" name="pt330"/>
            <p:cNvSpPr/>
            <p:nvPr/>
          </p:nvSpPr>
          <p:spPr>
            <a:xfrm>
              <a:off x="7162940" y="4529902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1" name="pt331"/>
            <p:cNvSpPr/>
            <p:nvPr/>
          </p:nvSpPr>
          <p:spPr>
            <a:xfrm>
              <a:off x="7218059" y="4643012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2" name="pt332"/>
            <p:cNvSpPr/>
            <p:nvPr/>
          </p:nvSpPr>
          <p:spPr>
            <a:xfrm>
              <a:off x="7281928" y="4555219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3" name="pt333"/>
            <p:cNvSpPr/>
            <p:nvPr/>
          </p:nvSpPr>
          <p:spPr>
            <a:xfrm>
              <a:off x="7345797" y="4601841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4" name="pt334"/>
            <p:cNvSpPr/>
            <p:nvPr/>
          </p:nvSpPr>
          <p:spPr>
            <a:xfrm>
              <a:off x="7416633" y="4584712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5" name="pt335"/>
            <p:cNvSpPr/>
            <p:nvPr/>
          </p:nvSpPr>
          <p:spPr>
            <a:xfrm>
              <a:off x="7488805" y="458400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6" name="pt336"/>
            <p:cNvSpPr/>
            <p:nvPr/>
          </p:nvSpPr>
          <p:spPr>
            <a:xfrm>
              <a:off x="7563865" y="4548500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7" name="pt337"/>
            <p:cNvSpPr/>
            <p:nvPr/>
          </p:nvSpPr>
          <p:spPr>
            <a:xfrm>
              <a:off x="7640488" y="453533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8" name="pt338"/>
            <p:cNvSpPr/>
            <p:nvPr/>
          </p:nvSpPr>
          <p:spPr>
            <a:xfrm>
              <a:off x="7724239" y="459301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9" name="pt339"/>
            <p:cNvSpPr/>
            <p:nvPr/>
          </p:nvSpPr>
          <p:spPr>
            <a:xfrm>
              <a:off x="7845534" y="5251747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0" name="pt340"/>
            <p:cNvSpPr/>
            <p:nvPr/>
          </p:nvSpPr>
          <p:spPr>
            <a:xfrm>
              <a:off x="7966828" y="527339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1" name="pt341"/>
            <p:cNvSpPr/>
            <p:nvPr/>
          </p:nvSpPr>
          <p:spPr>
            <a:xfrm>
              <a:off x="8092788" y="4635553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2" name="pt342"/>
            <p:cNvSpPr/>
            <p:nvPr/>
          </p:nvSpPr>
          <p:spPr>
            <a:xfrm>
              <a:off x="8335018" y="4444184"/>
              <a:ext cx="36101" cy="3610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3" name="pl343"/>
            <p:cNvSpPr/>
            <p:nvPr/>
          </p:nvSpPr>
          <p:spPr>
            <a:xfrm>
              <a:off x="5943131" y="4375207"/>
              <a:ext cx="2409938" cy="321584"/>
            </a:xfrm>
            <a:custGeom>
              <a:avLst/>
              <a:gdLst/>
              <a:ahLst/>
              <a:cxnLst/>
              <a:rect l="0" t="0" r="0" b="0"/>
              <a:pathLst>
                <a:path w="2409938" h="321584">
                  <a:moveTo>
                    <a:pt x="0" y="295561"/>
                  </a:moveTo>
                  <a:lnTo>
                    <a:pt x="61793" y="309661"/>
                  </a:lnTo>
                  <a:lnTo>
                    <a:pt x="123586" y="319224"/>
                  </a:lnTo>
                  <a:lnTo>
                    <a:pt x="185379" y="321584"/>
                  </a:lnTo>
                  <a:lnTo>
                    <a:pt x="247173" y="314214"/>
                  </a:lnTo>
                  <a:lnTo>
                    <a:pt x="308966" y="296983"/>
                  </a:lnTo>
                  <a:lnTo>
                    <a:pt x="370759" y="273522"/>
                  </a:lnTo>
                  <a:lnTo>
                    <a:pt x="432553" y="249064"/>
                  </a:lnTo>
                  <a:lnTo>
                    <a:pt x="494346" y="227936"/>
                  </a:lnTo>
                  <a:lnTo>
                    <a:pt x="556139" y="212652"/>
                  </a:lnTo>
                  <a:lnTo>
                    <a:pt x="617932" y="203201"/>
                  </a:lnTo>
                  <a:lnTo>
                    <a:pt x="679726" y="198472"/>
                  </a:lnTo>
                  <a:lnTo>
                    <a:pt x="741519" y="196879"/>
                  </a:lnTo>
                  <a:lnTo>
                    <a:pt x="803312" y="196550"/>
                  </a:lnTo>
                  <a:lnTo>
                    <a:pt x="865106" y="195610"/>
                  </a:lnTo>
                  <a:lnTo>
                    <a:pt x="926899" y="192625"/>
                  </a:lnTo>
                  <a:lnTo>
                    <a:pt x="988692" y="187074"/>
                  </a:lnTo>
                  <a:lnTo>
                    <a:pt x="1050485" y="179466"/>
                  </a:lnTo>
                  <a:lnTo>
                    <a:pt x="1112279" y="171009"/>
                  </a:lnTo>
                  <a:lnTo>
                    <a:pt x="1174072" y="163155"/>
                  </a:lnTo>
                  <a:lnTo>
                    <a:pt x="1235865" y="157264"/>
                  </a:lnTo>
                  <a:lnTo>
                    <a:pt x="1297659" y="154094"/>
                  </a:lnTo>
                  <a:lnTo>
                    <a:pt x="1359452" y="153704"/>
                  </a:lnTo>
                  <a:lnTo>
                    <a:pt x="1421245" y="155851"/>
                  </a:lnTo>
                  <a:lnTo>
                    <a:pt x="1483038" y="160069"/>
                  </a:lnTo>
                  <a:lnTo>
                    <a:pt x="1544832" y="165689"/>
                  </a:lnTo>
                  <a:lnTo>
                    <a:pt x="1606625" y="171845"/>
                  </a:lnTo>
                  <a:lnTo>
                    <a:pt x="1668418" y="177495"/>
                  </a:lnTo>
                  <a:lnTo>
                    <a:pt x="1730212" y="181480"/>
                  </a:lnTo>
                  <a:lnTo>
                    <a:pt x="1792005" y="182664"/>
                  </a:lnTo>
                  <a:lnTo>
                    <a:pt x="1853798" y="180133"/>
                  </a:lnTo>
                  <a:lnTo>
                    <a:pt x="1915591" y="173361"/>
                  </a:lnTo>
                  <a:lnTo>
                    <a:pt x="1977385" y="162264"/>
                  </a:lnTo>
                  <a:lnTo>
                    <a:pt x="2039178" y="147118"/>
                  </a:lnTo>
                  <a:lnTo>
                    <a:pt x="2100971" y="128403"/>
                  </a:lnTo>
                  <a:lnTo>
                    <a:pt x="2162765" y="106679"/>
                  </a:lnTo>
                  <a:lnTo>
                    <a:pt x="2224558" y="82494"/>
                  </a:lnTo>
                  <a:lnTo>
                    <a:pt x="2286351" y="56357"/>
                  </a:lnTo>
                  <a:lnTo>
                    <a:pt x="2348144" y="28723"/>
                  </a:lnTo>
                  <a:lnTo>
                    <a:pt x="2409938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4" name="pl344"/>
            <p:cNvSpPr/>
            <p:nvPr/>
          </p:nvSpPr>
          <p:spPr>
            <a:xfrm>
              <a:off x="5943131" y="4805270"/>
              <a:ext cx="2409938" cy="392899"/>
            </a:xfrm>
            <a:custGeom>
              <a:avLst/>
              <a:gdLst/>
              <a:ahLst/>
              <a:cxnLst/>
              <a:rect l="0" t="0" r="0" b="0"/>
              <a:pathLst>
                <a:path w="2409938" h="392899">
                  <a:moveTo>
                    <a:pt x="0" y="290613"/>
                  </a:moveTo>
                  <a:lnTo>
                    <a:pt x="61793" y="232793"/>
                  </a:lnTo>
                  <a:lnTo>
                    <a:pt x="123586" y="180070"/>
                  </a:lnTo>
                  <a:lnTo>
                    <a:pt x="185379" y="135664"/>
                  </a:lnTo>
                  <a:lnTo>
                    <a:pt x="247173" y="102661"/>
                  </a:lnTo>
                  <a:lnTo>
                    <a:pt x="308966" y="81751"/>
                  </a:lnTo>
                  <a:lnTo>
                    <a:pt x="370759" y="69858"/>
                  </a:lnTo>
                  <a:lnTo>
                    <a:pt x="432553" y="62309"/>
                  </a:lnTo>
                  <a:lnTo>
                    <a:pt x="494346" y="55334"/>
                  </a:lnTo>
                  <a:lnTo>
                    <a:pt x="556139" y="46827"/>
                  </a:lnTo>
                  <a:lnTo>
                    <a:pt x="617932" y="36624"/>
                  </a:lnTo>
                  <a:lnTo>
                    <a:pt x="679726" y="25523"/>
                  </a:lnTo>
                  <a:lnTo>
                    <a:pt x="741519" y="14796"/>
                  </a:lnTo>
                  <a:lnTo>
                    <a:pt x="803312" y="5998"/>
                  </a:lnTo>
                  <a:lnTo>
                    <a:pt x="865106" y="693"/>
                  </a:lnTo>
                  <a:lnTo>
                    <a:pt x="926899" y="0"/>
                  </a:lnTo>
                  <a:lnTo>
                    <a:pt x="988692" y="4124"/>
                  </a:lnTo>
                  <a:lnTo>
                    <a:pt x="1050485" y="12243"/>
                  </a:lnTo>
                  <a:lnTo>
                    <a:pt x="1112279" y="22834"/>
                  </a:lnTo>
                  <a:lnTo>
                    <a:pt x="1174072" y="34132"/>
                  </a:lnTo>
                  <a:lnTo>
                    <a:pt x="1235865" y="44467"/>
                  </a:lnTo>
                  <a:lnTo>
                    <a:pt x="1297659" y="52907"/>
                  </a:lnTo>
                  <a:lnTo>
                    <a:pt x="1359452" y="59343"/>
                  </a:lnTo>
                  <a:lnTo>
                    <a:pt x="1421245" y="63977"/>
                  </a:lnTo>
                  <a:lnTo>
                    <a:pt x="1483038" y="67231"/>
                  </a:lnTo>
                  <a:lnTo>
                    <a:pt x="1544832" y="69730"/>
                  </a:lnTo>
                  <a:lnTo>
                    <a:pt x="1606625" y="72296"/>
                  </a:lnTo>
                  <a:lnTo>
                    <a:pt x="1668418" y="75931"/>
                  </a:lnTo>
                  <a:lnTo>
                    <a:pt x="1730212" y="81749"/>
                  </a:lnTo>
                  <a:lnTo>
                    <a:pt x="1792005" y="90841"/>
                  </a:lnTo>
                  <a:lnTo>
                    <a:pt x="1853798" y="104082"/>
                  </a:lnTo>
                  <a:lnTo>
                    <a:pt x="1915591" y="121952"/>
                  </a:lnTo>
                  <a:lnTo>
                    <a:pt x="1977385" y="144491"/>
                  </a:lnTo>
                  <a:lnTo>
                    <a:pt x="2039178" y="171382"/>
                  </a:lnTo>
                  <a:lnTo>
                    <a:pt x="2100971" y="202101"/>
                  </a:lnTo>
                  <a:lnTo>
                    <a:pt x="2162765" y="236045"/>
                  </a:lnTo>
                  <a:lnTo>
                    <a:pt x="2224558" y="272622"/>
                  </a:lnTo>
                  <a:lnTo>
                    <a:pt x="2286351" y="311281"/>
                  </a:lnTo>
                  <a:lnTo>
                    <a:pt x="2348144" y="351523"/>
                  </a:lnTo>
                  <a:lnTo>
                    <a:pt x="2409938" y="392899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5" name="pl345"/>
            <p:cNvSpPr/>
            <p:nvPr/>
          </p:nvSpPr>
          <p:spPr>
            <a:xfrm>
              <a:off x="5822634" y="4317278"/>
              <a:ext cx="0" cy="1274435"/>
            </a:xfrm>
            <a:custGeom>
              <a:avLst/>
              <a:gdLst/>
              <a:ahLst/>
              <a:cxnLst/>
              <a:rect l="0" t="0" r="0" b="0"/>
              <a:pathLst>
                <a:path h="1274435">
                  <a:moveTo>
                    <a:pt x="0" y="1274435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6" name="tx346"/>
            <p:cNvSpPr/>
            <p:nvPr/>
          </p:nvSpPr>
          <p:spPr>
            <a:xfrm>
              <a:off x="5618802" y="5524799"/>
              <a:ext cx="135508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6</a:t>
              </a:r>
            </a:p>
          </p:txBody>
        </p:sp>
        <p:sp>
          <p:nvSpPr>
            <p:cNvPr id="347" name="tx347"/>
            <p:cNvSpPr/>
            <p:nvPr/>
          </p:nvSpPr>
          <p:spPr>
            <a:xfrm>
              <a:off x="5618802" y="5195242"/>
              <a:ext cx="135508" cy="11147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3</a:t>
              </a:r>
            </a:p>
          </p:txBody>
        </p:sp>
        <p:sp>
          <p:nvSpPr>
            <p:cNvPr id="348" name="tx348"/>
            <p:cNvSpPr/>
            <p:nvPr/>
          </p:nvSpPr>
          <p:spPr>
            <a:xfrm>
              <a:off x="5669552" y="4865834"/>
              <a:ext cx="84757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349" name="tx349"/>
            <p:cNvSpPr/>
            <p:nvPr/>
          </p:nvSpPr>
          <p:spPr>
            <a:xfrm>
              <a:off x="5669552" y="4536276"/>
              <a:ext cx="84757" cy="11147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350" name="pl350"/>
            <p:cNvSpPr/>
            <p:nvPr/>
          </p:nvSpPr>
          <p:spPr>
            <a:xfrm>
              <a:off x="5784676" y="5581651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1" name="pl351"/>
            <p:cNvSpPr/>
            <p:nvPr/>
          </p:nvSpPr>
          <p:spPr>
            <a:xfrm>
              <a:off x="5784676" y="5252169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2" name="pl352"/>
            <p:cNvSpPr/>
            <p:nvPr/>
          </p:nvSpPr>
          <p:spPr>
            <a:xfrm>
              <a:off x="5784676" y="4922686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3" name="pl353"/>
            <p:cNvSpPr/>
            <p:nvPr/>
          </p:nvSpPr>
          <p:spPr>
            <a:xfrm>
              <a:off x="5784676" y="4593203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4" name="pl354"/>
            <p:cNvSpPr/>
            <p:nvPr/>
          </p:nvSpPr>
          <p:spPr>
            <a:xfrm>
              <a:off x="5822634" y="5591714"/>
              <a:ext cx="2650932" cy="0"/>
            </a:xfrm>
            <a:custGeom>
              <a:avLst/>
              <a:gdLst/>
              <a:ahLst/>
              <a:cxnLst/>
              <a:rect l="0" t="0" r="0" b="0"/>
              <a:pathLst>
                <a:path w="2650932">
                  <a:moveTo>
                    <a:pt x="0" y="0"/>
                  </a:moveTo>
                  <a:lnTo>
                    <a:pt x="2650932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5" name="pl355"/>
            <p:cNvSpPr/>
            <p:nvPr/>
          </p:nvSpPr>
          <p:spPr>
            <a:xfrm>
              <a:off x="6091943" y="5591714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6" name="pl356"/>
            <p:cNvSpPr/>
            <p:nvPr/>
          </p:nvSpPr>
          <p:spPr>
            <a:xfrm>
              <a:off x="6386193" y="5591714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7" name="pl357"/>
            <p:cNvSpPr/>
            <p:nvPr/>
          </p:nvSpPr>
          <p:spPr>
            <a:xfrm>
              <a:off x="6702153" y="5591714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8" name="pl358"/>
            <p:cNvSpPr/>
            <p:nvPr/>
          </p:nvSpPr>
          <p:spPr>
            <a:xfrm>
              <a:off x="6989681" y="5591714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9" name="pl359"/>
            <p:cNvSpPr/>
            <p:nvPr/>
          </p:nvSpPr>
          <p:spPr>
            <a:xfrm>
              <a:off x="7300261" y="5591714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60" name="pl360"/>
            <p:cNvSpPr/>
            <p:nvPr/>
          </p:nvSpPr>
          <p:spPr>
            <a:xfrm>
              <a:off x="7603370" y="5591714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61" name="pl361"/>
            <p:cNvSpPr/>
            <p:nvPr/>
          </p:nvSpPr>
          <p:spPr>
            <a:xfrm>
              <a:off x="7736678" y="5591714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62" name="pl362"/>
            <p:cNvSpPr/>
            <p:nvPr/>
          </p:nvSpPr>
          <p:spPr>
            <a:xfrm>
              <a:off x="8232598" y="5591714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63" name="tx363"/>
            <p:cNvSpPr/>
            <p:nvPr/>
          </p:nvSpPr>
          <p:spPr>
            <a:xfrm>
              <a:off x="5943636" y="5657731"/>
              <a:ext cx="296614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26</a:t>
              </a:r>
            </a:p>
          </p:txBody>
        </p:sp>
        <p:sp>
          <p:nvSpPr>
            <p:cNvPr id="364" name="tx364"/>
            <p:cNvSpPr/>
            <p:nvPr/>
          </p:nvSpPr>
          <p:spPr>
            <a:xfrm>
              <a:off x="6343814" y="5659591"/>
              <a:ext cx="84757" cy="10953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365" name="tx365"/>
            <p:cNvSpPr/>
            <p:nvPr/>
          </p:nvSpPr>
          <p:spPr>
            <a:xfrm>
              <a:off x="6596225" y="5659591"/>
              <a:ext cx="211856" cy="10953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.7</a:t>
              </a:r>
            </a:p>
          </p:txBody>
        </p:sp>
        <p:sp>
          <p:nvSpPr>
            <p:cNvPr id="366" name="tx366"/>
            <p:cNvSpPr/>
            <p:nvPr/>
          </p:nvSpPr>
          <p:spPr>
            <a:xfrm>
              <a:off x="6883752" y="5657656"/>
              <a:ext cx="211856" cy="11147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.3</a:t>
              </a:r>
            </a:p>
          </p:txBody>
        </p:sp>
        <p:sp>
          <p:nvSpPr>
            <p:cNvPr id="367" name="tx367"/>
            <p:cNvSpPr/>
            <p:nvPr/>
          </p:nvSpPr>
          <p:spPr>
            <a:xfrm>
              <a:off x="7194333" y="5657731"/>
              <a:ext cx="211856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.4</a:t>
              </a:r>
            </a:p>
          </p:txBody>
        </p:sp>
        <p:sp>
          <p:nvSpPr>
            <p:cNvPr id="368" name="tx368"/>
            <p:cNvSpPr/>
            <p:nvPr/>
          </p:nvSpPr>
          <p:spPr>
            <a:xfrm>
              <a:off x="7497442" y="5657731"/>
              <a:ext cx="211856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.8</a:t>
              </a:r>
            </a:p>
          </p:txBody>
        </p:sp>
        <p:sp>
          <p:nvSpPr>
            <p:cNvPr id="369" name="tx369"/>
            <p:cNvSpPr/>
            <p:nvPr/>
          </p:nvSpPr>
          <p:spPr>
            <a:xfrm>
              <a:off x="7651920" y="5657731"/>
              <a:ext cx="169515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370" name="tx370"/>
            <p:cNvSpPr/>
            <p:nvPr/>
          </p:nvSpPr>
          <p:spPr>
            <a:xfrm>
              <a:off x="8147840" y="5657731"/>
              <a:ext cx="169515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5</a:t>
              </a:r>
            </a:p>
          </p:txBody>
        </p:sp>
        <p:sp>
          <p:nvSpPr>
            <p:cNvPr id="371" name="tx371"/>
            <p:cNvSpPr/>
            <p:nvPr/>
          </p:nvSpPr>
          <p:spPr>
            <a:xfrm>
              <a:off x="6950549" y="5833578"/>
              <a:ext cx="395101" cy="1293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ime</a:t>
              </a:r>
            </a:p>
          </p:txBody>
        </p:sp>
        <p:sp>
          <p:nvSpPr>
            <p:cNvPr id="372" name="tx372"/>
            <p:cNvSpPr/>
            <p:nvPr/>
          </p:nvSpPr>
          <p:spPr>
            <a:xfrm rot="-5400000">
              <a:off x="4866116" y="4871066"/>
              <a:ext cx="1205445" cy="16686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Beta(t) for ESR</a:t>
              </a:r>
            </a:p>
          </p:txBody>
        </p:sp>
        <p:sp>
          <p:nvSpPr>
            <p:cNvPr id="373" name="tx373"/>
            <p:cNvSpPr/>
            <p:nvPr/>
          </p:nvSpPr>
          <p:spPr>
            <a:xfrm>
              <a:off x="5422622" y="4024004"/>
              <a:ext cx="3174305" cy="18831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600" dirty="0" err="1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choenfeld</a:t>
              </a:r>
              <a:r>
                <a:rPr sz="16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 Individual Test p: 0.373</a:t>
              </a:r>
            </a:p>
          </p:txBody>
        </p:sp>
        <p:sp>
          <p:nvSpPr>
            <p:cNvPr id="374" name="tx374"/>
            <p:cNvSpPr/>
            <p:nvPr/>
          </p:nvSpPr>
          <p:spPr>
            <a:xfrm>
              <a:off x="4218024" y="1508998"/>
              <a:ext cx="2262113" cy="14123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6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Global </a:t>
              </a:r>
              <a:r>
                <a:rPr sz="1600" dirty="0" err="1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choenfeld</a:t>
              </a:r>
              <a:r>
                <a:rPr sz="16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 Test p: 0.6889</a:t>
              </a:r>
            </a:p>
          </p:txBody>
        </p:sp>
        <p:sp>
          <p:nvSpPr>
            <p:cNvPr id="375" name="tx375"/>
            <p:cNvSpPr/>
            <p:nvPr/>
          </p:nvSpPr>
          <p:spPr>
            <a:xfrm>
              <a:off x="5349081" y="1869692"/>
              <a:ext cx="0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endParaRPr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05</Words>
  <Application>Microsoft Office PowerPoint</Application>
  <PresentationFormat>自定义</PresentationFormat>
  <Paragraphs>6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 Wenseleers</dc:creator>
  <cp:lastModifiedBy>卓 小煌</cp:lastModifiedBy>
  <cp:revision>8</cp:revision>
  <dcterms:created xsi:type="dcterms:W3CDTF">2015-07-14T21:05:00Z</dcterms:created>
  <dcterms:modified xsi:type="dcterms:W3CDTF">2019-09-15T04:37:11Z</dcterms:modified>
</cp:coreProperties>
</file>